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allistrea, Lisa" initials="BL" lastIdx="5" clrIdx="0">
    <p:extLst>
      <p:ext uri="{19B8F6BF-5375-455C-9EA6-DF929625EA0E}">
        <p15:presenceInfo xmlns:p15="http://schemas.microsoft.com/office/powerpoint/2012/main" userId="S-1-5-21-1876523541-981950538-929701000-266707" providerId="AD"/>
      </p:ext>
    </p:extLst>
  </p:cmAuthor>
  <p:cmAuthor id="2" name="Ballistrea, Lisa M." initials="BLM" lastIdx="1" clrIdx="1">
    <p:extLst>
      <p:ext uri="{19B8F6BF-5375-455C-9EA6-DF929625EA0E}">
        <p15:presenceInfo xmlns:p15="http://schemas.microsoft.com/office/powerpoint/2012/main" userId="S::Lisa.Ballistrea@va.gov::93bc5262-92bf-4d82-b860-6e64b927ef9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0398" autoAdjust="0"/>
  </p:normalViewPr>
  <p:slideViewPr>
    <p:cSldViewPr snapToGrid="0">
      <p:cViewPr varScale="1">
        <p:scale>
          <a:sx n="75" d="100"/>
          <a:sy n="75" d="100"/>
        </p:scale>
        <p:origin x="307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flickr.com/photos/hadock/4401451338/" TargetMode="External"/><Relationship Id="rId7" Type="http://schemas.openxmlformats.org/officeDocument/2006/relationships/hyperlink" Target="http://smbirdbrain.blogspot.com/2012/08/nonprofit-pulse-survey.html" TargetMode="External"/><Relationship Id="rId2" Type="http://schemas.openxmlformats.org/officeDocument/2006/relationships/image" Target="../media/image4.jpg"/><Relationship Id="rId1" Type="http://schemas.openxmlformats.org/officeDocument/2006/relationships/image" Target="../media/image3.jpeg"/><Relationship Id="rId6" Type="http://schemas.openxmlformats.org/officeDocument/2006/relationships/image" Target="../media/image6.jpg"/><Relationship Id="rId5" Type="http://schemas.openxmlformats.org/officeDocument/2006/relationships/hyperlink" Target="http://flickr.com/photos/cig/2869034186" TargetMode="External"/><Relationship Id="rId4" Type="http://schemas.openxmlformats.org/officeDocument/2006/relationships/image" Target="../media/image5.jp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flickr.com/photos/hadock/4401451338/" TargetMode="External"/><Relationship Id="rId7" Type="http://schemas.openxmlformats.org/officeDocument/2006/relationships/hyperlink" Target="http://smbirdbrain.blogspot.com/2012/08/nonprofit-pulse-survey.html" TargetMode="External"/><Relationship Id="rId2" Type="http://schemas.openxmlformats.org/officeDocument/2006/relationships/image" Target="../media/image4.jpg"/><Relationship Id="rId1" Type="http://schemas.openxmlformats.org/officeDocument/2006/relationships/image" Target="../media/image3.jpeg"/><Relationship Id="rId6" Type="http://schemas.openxmlformats.org/officeDocument/2006/relationships/image" Target="../media/image6.jpg"/><Relationship Id="rId5" Type="http://schemas.openxmlformats.org/officeDocument/2006/relationships/hyperlink" Target="http://flickr.com/photos/cig/2869034186" TargetMode="External"/><Relationship Id="rId4" Type="http://schemas.openxmlformats.org/officeDocument/2006/relationships/image" Target="../media/image5.jp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5_2">
  <dgm:title val=""/>
  <dgm:desc val=""/>
  <dgm:catLst>
    <dgm:cat type="accent5" pri="11200"/>
  </dgm:catLst>
  <dgm:styleLbl name="node0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5"/>
    </dgm:fillClrLst>
    <dgm:linClrLst meth="repeat">
      <a:schemeClr val="accent5"/>
    </dgm:linClrLst>
    <dgm:effectClrLst/>
    <dgm:txLinClrLst/>
    <dgm:txFillClrLst/>
    <dgm:txEffectClrLst/>
  </dgm:styleLbl>
  <dgm:styleLbl name="lnNode1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8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5_1">
  <dgm:title val=""/>
  <dgm:desc val=""/>
  <dgm:catLst>
    <dgm:cat type="accent5" pri="11100"/>
  </dgm:catLst>
  <dgm:styleLbl name="node0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5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5"/>
    </dgm:fillClrLst>
    <dgm:linClrLst meth="repeat">
      <a:schemeClr val="accent5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accent5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5">
        <a:alpha val="4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8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7762569-BC22-45D9-8EB0-FC3E30B9E09D}" type="doc">
      <dgm:prSet loTypeId="urn:microsoft.com/office/officeart/2005/8/layout/list1" loCatId="list" qsTypeId="urn:microsoft.com/office/officeart/2005/8/quickstyle/3d1" qsCatId="3D" csTypeId="urn:microsoft.com/office/officeart/2005/8/colors/accent5_2" csCatId="accent5" phldr="1"/>
      <dgm:spPr/>
      <dgm:t>
        <a:bodyPr/>
        <a:lstStyle/>
        <a:p>
          <a:endParaRPr lang="en-US"/>
        </a:p>
      </dgm:t>
    </dgm:pt>
    <dgm:pt modelId="{E842E16B-D5FD-498B-8239-EC846B1CBA08}">
      <dgm:prSet custT="1"/>
      <dgm:spPr/>
      <dgm:t>
        <a:bodyPr/>
        <a:lstStyle/>
        <a:p>
          <a:r>
            <a: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Eligibility: </a:t>
          </a:r>
          <a:endParaRPr lang="en-US" sz="14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58B0332-97BA-4DF4-9110-25F2C267EF26}" type="parTrans" cxnId="{38FCC695-0AAB-48DF-A177-CC025C7942F6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794AF71-5DBA-491C-89CF-B88D75333465}" type="sibTrans" cxnId="{38FCC695-0AAB-48DF-A177-CC025C7942F6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679B428-FADD-443E-9E64-6C7C0923FB87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18+</a:t>
          </a:r>
        </a:p>
      </dgm:t>
    </dgm:pt>
    <dgm:pt modelId="{30B50843-16CD-4E09-A73B-23741E32E0F9}" type="parTrans" cxnId="{D9286530-DA28-4008-B560-55D624F54A47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707B600-535D-438D-A4AF-9B843E464C3E}" type="sibTrans" cxnId="{D9286530-DA28-4008-B560-55D624F54A47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53B2D00-B3CF-4474-96EE-DDD7CE7C60D7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Veteran with chronic pain &amp; PTSD.</a:t>
          </a:r>
        </a:p>
      </dgm:t>
    </dgm:pt>
    <dgm:pt modelId="{EC0F6F4B-64CB-4E8C-9AF0-AD985165B5DC}" type="parTrans" cxnId="{62BD683E-0474-479B-A1E0-45E83576B3B2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6613BD9-A1E0-4BCF-9B6E-2931AB9300D9}" type="sibTrans" cxnId="{62BD683E-0474-479B-A1E0-45E83576B3B2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DE301A0-4823-494F-94AC-2C9FD965787A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Partner who is willing to join. (Spouse, significant other, caregiver, family member etc.)</a:t>
          </a:r>
        </a:p>
      </dgm:t>
    </dgm:pt>
    <dgm:pt modelId="{057B2C81-21A2-43F0-86F7-6F876AF936DA}" type="parTrans" cxnId="{3C626234-77CD-4AE2-B3E0-E6DB89738B14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7C9F9D0-9B88-4F12-9C13-A382F6FE7293}" type="sibTrans" cxnId="{3C626234-77CD-4AE2-B3E0-E6DB89738B14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1C2E9AB-3FD7-4FA3-97ED-30657BD484E4}">
      <dgm:prSet custT="1"/>
      <dgm:spPr/>
      <dgm:t>
        <a:bodyPr/>
        <a:lstStyle/>
        <a:p>
          <a:r>
            <a: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Where does the study take place?</a:t>
          </a:r>
          <a:endParaRPr lang="en-US" sz="14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87B59F3-E3EB-48C9-8A56-4B6C56B917B5}" type="parTrans" cxnId="{D60785C9-4D1D-41D5-BC5C-99CD6F7C1D07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CD7B2CE-284E-414A-A4C4-9B31D3D2EE5E}" type="sibTrans" cxnId="{D60785C9-4D1D-41D5-BC5C-99CD6F7C1D07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63911B8-DA45-45E5-9844-8E50ACAC911A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Online using mobile phone and/or web</a:t>
          </a:r>
        </a:p>
      </dgm:t>
    </dgm:pt>
    <dgm:pt modelId="{572F98AB-A648-4987-A61D-46BEF614EEE1}" type="parTrans" cxnId="{4663FE8C-685C-4542-885B-5FB2C88B90D3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1643813-A1AA-4E1C-8E40-82C87B76D21A}" type="sibTrans" cxnId="{4663FE8C-685C-4542-885B-5FB2C88B90D3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6E23DDB-1304-4D29-A169-A31BB30D3EE1}">
      <dgm:prSet custT="1"/>
      <dgm:spPr/>
      <dgm:t>
        <a:bodyPr/>
        <a:lstStyle/>
        <a:p>
          <a:r>
            <a: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ossible Benefits:</a:t>
          </a:r>
        </a:p>
      </dgm:t>
    </dgm:pt>
    <dgm:pt modelId="{87675A7B-20FF-4F38-B5F7-3092C0C9D5A9}" type="parTrans" cxnId="{1C571D65-C2F8-4BE5-8480-24BB8B6F44F3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810DA2A-6B0A-450F-B615-B1D729BA3D2C}" type="sibTrans" cxnId="{1C571D65-C2F8-4BE5-8480-24BB8B6F44F3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5BF2FB-04E6-44F3-8DDD-245E0852E232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Access to internet or mobile application</a:t>
          </a:r>
        </a:p>
      </dgm:t>
    </dgm:pt>
    <dgm:pt modelId="{3C139934-4F19-40D6-932D-8E1EAC34B785}" type="parTrans" cxnId="{F5DA0742-1DEC-4B0B-B61E-D316CF93088B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E79EF76-14D7-4005-AA2D-4291C53B3ACE}" type="sibTrans" cxnId="{F5DA0742-1DEC-4B0B-B61E-D316CF93088B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EA480B9-1095-4A3C-99F8-045582327E87}">
      <dgm:prSet custT="1"/>
      <dgm:spPr/>
      <dgm:t>
        <a:bodyPr/>
        <a:lstStyle/>
        <a:p>
          <a:r>
            <a:rPr lang="en-US" sz="1200" b="0" dirty="0">
              <a:latin typeface="Arial" panose="020B0604020202020204" pitchFamily="34" charset="0"/>
              <a:cs typeface="Arial" panose="020B0604020202020204" pitchFamily="34" charset="0"/>
            </a:rPr>
            <a:t>Reduce pain, anxiety &amp; stress, promote individual well-being &amp; improve quality of relationship</a:t>
          </a:r>
          <a:endParaRPr lang="en-US" sz="12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548DEE-95F4-4ED0-BFB6-7C5E03EB3527}" type="parTrans" cxnId="{E6198169-6989-46B2-878F-D55BDC5BDDB6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6C86A11-8D0B-47E9-9EBE-B3248AF827A1}" type="sibTrans" cxnId="{E6198169-6989-46B2-878F-D55BDC5BDDB6}">
      <dgm:prSet/>
      <dgm:spPr/>
      <dgm:t>
        <a:bodyPr/>
        <a:lstStyle/>
        <a:p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0E15827-DAEE-4C47-BE35-3C8E3F4341F6}">
      <dgm:prSet custT="1"/>
      <dgm:spPr/>
      <dgm:t>
        <a:bodyPr/>
        <a:lstStyle/>
        <a:p>
          <a:r>
            <a:rPr lang="en-US" sz="1200" dirty="0">
              <a:latin typeface="Arial" panose="020B0604020202020204" pitchFamily="34" charset="0"/>
              <a:cs typeface="Arial" panose="020B0604020202020204" pitchFamily="34" charset="0"/>
            </a:rPr>
            <a:t>Reimbursement for time &amp; effort, up to $140. </a:t>
          </a:r>
          <a:endParaRPr lang="en-US" sz="12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C73D7DE-D1BC-4D7C-BE46-EB037C87C825}" type="parTrans" cxnId="{7C7B11F6-9AAF-41F4-9C09-E396D4DDCD9B}">
      <dgm:prSet/>
      <dgm:spPr/>
      <dgm:t>
        <a:bodyPr/>
        <a:lstStyle/>
        <a:p>
          <a:endParaRPr lang="en-US"/>
        </a:p>
      </dgm:t>
    </dgm:pt>
    <dgm:pt modelId="{B70D00FE-A276-4553-8FAD-241D97019377}" type="sibTrans" cxnId="{7C7B11F6-9AAF-41F4-9C09-E396D4DDCD9B}">
      <dgm:prSet/>
      <dgm:spPr/>
      <dgm:t>
        <a:bodyPr/>
        <a:lstStyle/>
        <a:p>
          <a:endParaRPr lang="en-US"/>
        </a:p>
      </dgm:t>
    </dgm:pt>
    <dgm:pt modelId="{920395AC-91DC-4EE8-BC49-753B6FFDB977}" type="pres">
      <dgm:prSet presAssocID="{37762569-BC22-45D9-8EB0-FC3E30B9E09D}" presName="linear" presStyleCnt="0">
        <dgm:presLayoutVars>
          <dgm:dir/>
          <dgm:animLvl val="lvl"/>
          <dgm:resizeHandles val="exact"/>
        </dgm:presLayoutVars>
      </dgm:prSet>
      <dgm:spPr/>
    </dgm:pt>
    <dgm:pt modelId="{1FE0C8F6-CCDB-4892-A7A0-3E97613E3D4A}" type="pres">
      <dgm:prSet presAssocID="{E842E16B-D5FD-498B-8239-EC846B1CBA08}" presName="parentLin" presStyleCnt="0"/>
      <dgm:spPr/>
    </dgm:pt>
    <dgm:pt modelId="{76AE0747-A560-4374-8A34-553A2591D7F7}" type="pres">
      <dgm:prSet presAssocID="{E842E16B-D5FD-498B-8239-EC846B1CBA08}" presName="parentLeftMargin" presStyleLbl="node1" presStyleIdx="0" presStyleCnt="3"/>
      <dgm:spPr/>
    </dgm:pt>
    <dgm:pt modelId="{12E1ABFC-C78C-4F0D-8E7D-F30F4EE457C2}" type="pres">
      <dgm:prSet presAssocID="{E842E16B-D5FD-498B-8239-EC846B1CBA08}" presName="parentText" presStyleLbl="node1" presStyleIdx="0" presStyleCnt="3">
        <dgm:presLayoutVars>
          <dgm:chMax val="0"/>
          <dgm:bulletEnabled val="1"/>
        </dgm:presLayoutVars>
      </dgm:prSet>
      <dgm:spPr/>
    </dgm:pt>
    <dgm:pt modelId="{D52A9C77-B8FA-4A01-9F87-AC721D893948}" type="pres">
      <dgm:prSet presAssocID="{E842E16B-D5FD-498B-8239-EC846B1CBA08}" presName="negativeSpace" presStyleCnt="0"/>
      <dgm:spPr/>
    </dgm:pt>
    <dgm:pt modelId="{15862389-6CB2-4FD9-A139-0DA95CF37254}" type="pres">
      <dgm:prSet presAssocID="{E842E16B-D5FD-498B-8239-EC846B1CBA08}" presName="childText" presStyleLbl="conFgAcc1" presStyleIdx="0" presStyleCnt="3">
        <dgm:presLayoutVars>
          <dgm:bulletEnabled val="1"/>
        </dgm:presLayoutVars>
      </dgm:prSet>
      <dgm:spPr/>
    </dgm:pt>
    <dgm:pt modelId="{64BEF30E-20C2-40B4-9736-BE9B63EC1175}" type="pres">
      <dgm:prSet presAssocID="{9794AF71-5DBA-491C-89CF-B88D75333465}" presName="spaceBetweenRectangles" presStyleCnt="0"/>
      <dgm:spPr/>
    </dgm:pt>
    <dgm:pt modelId="{988490AE-BE09-48A0-A395-6C3643A756F6}" type="pres">
      <dgm:prSet presAssocID="{41C2E9AB-3FD7-4FA3-97ED-30657BD484E4}" presName="parentLin" presStyleCnt="0"/>
      <dgm:spPr/>
    </dgm:pt>
    <dgm:pt modelId="{29E049D4-CE53-49EE-9D37-9E1CB075BC49}" type="pres">
      <dgm:prSet presAssocID="{41C2E9AB-3FD7-4FA3-97ED-30657BD484E4}" presName="parentLeftMargin" presStyleLbl="node1" presStyleIdx="0" presStyleCnt="3"/>
      <dgm:spPr/>
    </dgm:pt>
    <dgm:pt modelId="{A68BC2BC-9001-48C3-8F1C-C51D7627644F}" type="pres">
      <dgm:prSet presAssocID="{41C2E9AB-3FD7-4FA3-97ED-30657BD484E4}" presName="parentText" presStyleLbl="node1" presStyleIdx="1" presStyleCnt="3">
        <dgm:presLayoutVars>
          <dgm:chMax val="0"/>
          <dgm:bulletEnabled val="1"/>
        </dgm:presLayoutVars>
      </dgm:prSet>
      <dgm:spPr/>
    </dgm:pt>
    <dgm:pt modelId="{B034BAA4-2F28-40A7-BBB9-92AFEBF736F8}" type="pres">
      <dgm:prSet presAssocID="{41C2E9AB-3FD7-4FA3-97ED-30657BD484E4}" presName="negativeSpace" presStyleCnt="0"/>
      <dgm:spPr/>
    </dgm:pt>
    <dgm:pt modelId="{90A98123-D996-419D-B76B-2B4D1F6AF0B3}" type="pres">
      <dgm:prSet presAssocID="{41C2E9AB-3FD7-4FA3-97ED-30657BD484E4}" presName="childText" presStyleLbl="conFgAcc1" presStyleIdx="1" presStyleCnt="3">
        <dgm:presLayoutVars>
          <dgm:bulletEnabled val="1"/>
        </dgm:presLayoutVars>
      </dgm:prSet>
      <dgm:spPr/>
    </dgm:pt>
    <dgm:pt modelId="{7F075120-7157-40E3-9EFB-F9D2A2FD8185}" type="pres">
      <dgm:prSet presAssocID="{7CD7B2CE-284E-414A-A4C4-9B31D3D2EE5E}" presName="spaceBetweenRectangles" presStyleCnt="0"/>
      <dgm:spPr/>
    </dgm:pt>
    <dgm:pt modelId="{6782B8BD-28FB-4521-811D-5E26CF5CE366}" type="pres">
      <dgm:prSet presAssocID="{56E23DDB-1304-4D29-A169-A31BB30D3EE1}" presName="parentLin" presStyleCnt="0"/>
      <dgm:spPr/>
    </dgm:pt>
    <dgm:pt modelId="{4EBB2C31-25E3-4CB7-A2A3-53271D63A6A1}" type="pres">
      <dgm:prSet presAssocID="{56E23DDB-1304-4D29-A169-A31BB30D3EE1}" presName="parentLeftMargin" presStyleLbl="node1" presStyleIdx="1" presStyleCnt="3"/>
      <dgm:spPr/>
    </dgm:pt>
    <dgm:pt modelId="{5210B3BC-0093-4D6C-9C93-5925B2F0BF78}" type="pres">
      <dgm:prSet presAssocID="{56E23DDB-1304-4D29-A169-A31BB30D3EE1}" presName="parentText" presStyleLbl="node1" presStyleIdx="2" presStyleCnt="3" custLinFactNeighborX="1420" custLinFactNeighborY="401">
        <dgm:presLayoutVars>
          <dgm:chMax val="0"/>
          <dgm:bulletEnabled val="1"/>
        </dgm:presLayoutVars>
      </dgm:prSet>
      <dgm:spPr/>
    </dgm:pt>
    <dgm:pt modelId="{897F5CCE-F4FB-4F37-AE7A-92952CC159EF}" type="pres">
      <dgm:prSet presAssocID="{56E23DDB-1304-4D29-A169-A31BB30D3EE1}" presName="negativeSpace" presStyleCnt="0"/>
      <dgm:spPr/>
    </dgm:pt>
    <dgm:pt modelId="{892495FD-6C39-483C-90E9-5AC5389A00C3}" type="pres">
      <dgm:prSet presAssocID="{56E23DDB-1304-4D29-A169-A31BB30D3EE1}" presName="childText" presStyleLbl="conFgAcc1" presStyleIdx="2" presStyleCnt="3">
        <dgm:presLayoutVars>
          <dgm:bulletEnabled val="1"/>
        </dgm:presLayoutVars>
      </dgm:prSet>
      <dgm:spPr/>
    </dgm:pt>
  </dgm:ptLst>
  <dgm:cxnLst>
    <dgm:cxn modelId="{92D10D01-F24B-480D-BE86-67D581CDB36E}" type="presOf" srcId="{BDE301A0-4823-494F-94AC-2C9FD965787A}" destId="{15862389-6CB2-4FD9-A139-0DA95CF37254}" srcOrd="0" destOrd="2" presId="urn:microsoft.com/office/officeart/2005/8/layout/list1"/>
    <dgm:cxn modelId="{5BE64C09-7ED7-4D24-9907-CCA1AED303FF}" type="presOf" srcId="{3A5BF2FB-04E6-44F3-8DDD-245E0852E232}" destId="{15862389-6CB2-4FD9-A139-0DA95CF37254}" srcOrd="0" destOrd="3" presId="urn:microsoft.com/office/officeart/2005/8/layout/list1"/>
    <dgm:cxn modelId="{0D890714-D75E-4899-A94D-1762C7D8AFBF}" type="presOf" srcId="{41C2E9AB-3FD7-4FA3-97ED-30657BD484E4}" destId="{A68BC2BC-9001-48C3-8F1C-C51D7627644F}" srcOrd="1" destOrd="0" presId="urn:microsoft.com/office/officeart/2005/8/layout/list1"/>
    <dgm:cxn modelId="{ED9D7D17-E04E-418F-9B82-703B71CD31D5}" type="presOf" srcId="{56E23DDB-1304-4D29-A169-A31BB30D3EE1}" destId="{4EBB2C31-25E3-4CB7-A2A3-53271D63A6A1}" srcOrd="0" destOrd="0" presId="urn:microsoft.com/office/officeart/2005/8/layout/list1"/>
    <dgm:cxn modelId="{D8BC4B27-5E58-48E0-9DD1-0D99B54DE477}" type="presOf" srcId="{37762569-BC22-45D9-8EB0-FC3E30B9E09D}" destId="{920395AC-91DC-4EE8-BC49-753B6FFDB977}" srcOrd="0" destOrd="0" presId="urn:microsoft.com/office/officeart/2005/8/layout/list1"/>
    <dgm:cxn modelId="{0DDF8927-428B-4B73-8F7B-028666A9716A}" type="presOf" srcId="{C0E15827-DAEE-4C47-BE35-3C8E3F4341F6}" destId="{892495FD-6C39-483C-90E9-5AC5389A00C3}" srcOrd="0" destOrd="1" presId="urn:microsoft.com/office/officeart/2005/8/layout/list1"/>
    <dgm:cxn modelId="{2C63D02B-EE27-40AC-B4A9-1A5C124E944C}" type="presOf" srcId="{CEA480B9-1095-4A3C-99F8-045582327E87}" destId="{892495FD-6C39-483C-90E9-5AC5389A00C3}" srcOrd="0" destOrd="0" presId="urn:microsoft.com/office/officeart/2005/8/layout/list1"/>
    <dgm:cxn modelId="{D9286530-DA28-4008-B560-55D624F54A47}" srcId="{E842E16B-D5FD-498B-8239-EC846B1CBA08}" destId="{1679B428-FADD-443E-9E64-6C7C0923FB87}" srcOrd="0" destOrd="0" parTransId="{30B50843-16CD-4E09-A73B-23741E32E0F9}" sibTransId="{D707B600-535D-438D-A4AF-9B843E464C3E}"/>
    <dgm:cxn modelId="{3C626234-77CD-4AE2-B3E0-E6DB89738B14}" srcId="{E842E16B-D5FD-498B-8239-EC846B1CBA08}" destId="{BDE301A0-4823-494F-94AC-2C9FD965787A}" srcOrd="2" destOrd="0" parTransId="{057B2C81-21A2-43F0-86F7-6F876AF936DA}" sibTransId="{A7C9F9D0-9B88-4F12-9C13-A382F6FE7293}"/>
    <dgm:cxn modelId="{62BD683E-0474-479B-A1E0-45E83576B3B2}" srcId="{E842E16B-D5FD-498B-8239-EC846B1CBA08}" destId="{553B2D00-B3CF-4474-96EE-DDD7CE7C60D7}" srcOrd="1" destOrd="0" parTransId="{EC0F6F4B-64CB-4E8C-9AF0-AD985165B5DC}" sibTransId="{A6613BD9-A1E0-4BCF-9B6E-2931AB9300D9}"/>
    <dgm:cxn modelId="{47E2E65E-9AAA-4B47-A397-CCA7003918BC}" type="presOf" srcId="{41C2E9AB-3FD7-4FA3-97ED-30657BD484E4}" destId="{29E049D4-CE53-49EE-9D37-9E1CB075BC49}" srcOrd="0" destOrd="0" presId="urn:microsoft.com/office/officeart/2005/8/layout/list1"/>
    <dgm:cxn modelId="{F5DA0742-1DEC-4B0B-B61E-D316CF93088B}" srcId="{E842E16B-D5FD-498B-8239-EC846B1CBA08}" destId="{3A5BF2FB-04E6-44F3-8DDD-245E0852E232}" srcOrd="3" destOrd="0" parTransId="{3C139934-4F19-40D6-932D-8E1EAC34B785}" sibTransId="{BE79EF76-14D7-4005-AA2D-4291C53B3ACE}"/>
    <dgm:cxn modelId="{1C571D65-C2F8-4BE5-8480-24BB8B6F44F3}" srcId="{37762569-BC22-45D9-8EB0-FC3E30B9E09D}" destId="{56E23DDB-1304-4D29-A169-A31BB30D3EE1}" srcOrd="2" destOrd="0" parTransId="{87675A7B-20FF-4F38-B5F7-3092C0C9D5A9}" sibTransId="{D810DA2A-6B0A-450F-B615-B1D729BA3D2C}"/>
    <dgm:cxn modelId="{E6198169-6989-46B2-878F-D55BDC5BDDB6}" srcId="{56E23DDB-1304-4D29-A169-A31BB30D3EE1}" destId="{CEA480B9-1095-4A3C-99F8-045582327E87}" srcOrd="0" destOrd="0" parTransId="{4A548DEE-95F4-4ED0-BFB6-7C5E03EB3527}" sibTransId="{46C86A11-8D0B-47E9-9EBE-B3248AF827A1}"/>
    <dgm:cxn modelId="{EE703972-A436-4CA3-9A04-B041144831A4}" type="presOf" srcId="{1679B428-FADD-443E-9E64-6C7C0923FB87}" destId="{15862389-6CB2-4FD9-A139-0DA95CF37254}" srcOrd="0" destOrd="0" presId="urn:microsoft.com/office/officeart/2005/8/layout/list1"/>
    <dgm:cxn modelId="{4663FE8C-685C-4542-885B-5FB2C88B90D3}" srcId="{41C2E9AB-3FD7-4FA3-97ED-30657BD484E4}" destId="{163911B8-DA45-45E5-9844-8E50ACAC911A}" srcOrd="0" destOrd="0" parTransId="{572F98AB-A648-4987-A61D-46BEF614EEE1}" sibTransId="{21643813-A1AA-4E1C-8E40-82C87B76D21A}"/>
    <dgm:cxn modelId="{38FCC695-0AAB-48DF-A177-CC025C7942F6}" srcId="{37762569-BC22-45D9-8EB0-FC3E30B9E09D}" destId="{E842E16B-D5FD-498B-8239-EC846B1CBA08}" srcOrd="0" destOrd="0" parTransId="{D58B0332-97BA-4DF4-9110-25F2C267EF26}" sibTransId="{9794AF71-5DBA-491C-89CF-B88D75333465}"/>
    <dgm:cxn modelId="{BC8FECBB-B1D4-427B-936E-EA1198568574}" type="presOf" srcId="{553B2D00-B3CF-4474-96EE-DDD7CE7C60D7}" destId="{15862389-6CB2-4FD9-A139-0DA95CF37254}" srcOrd="0" destOrd="1" presId="urn:microsoft.com/office/officeart/2005/8/layout/list1"/>
    <dgm:cxn modelId="{D60785C9-4D1D-41D5-BC5C-99CD6F7C1D07}" srcId="{37762569-BC22-45D9-8EB0-FC3E30B9E09D}" destId="{41C2E9AB-3FD7-4FA3-97ED-30657BD484E4}" srcOrd="1" destOrd="0" parTransId="{287B59F3-E3EB-48C9-8A56-4B6C56B917B5}" sibTransId="{7CD7B2CE-284E-414A-A4C4-9B31D3D2EE5E}"/>
    <dgm:cxn modelId="{691CEBD0-A923-4FC1-8D43-6572264CAB5E}" type="presOf" srcId="{56E23DDB-1304-4D29-A169-A31BB30D3EE1}" destId="{5210B3BC-0093-4D6C-9C93-5925B2F0BF78}" srcOrd="1" destOrd="0" presId="urn:microsoft.com/office/officeart/2005/8/layout/list1"/>
    <dgm:cxn modelId="{FC671BD3-1238-4B32-A64A-5861AF665B76}" type="presOf" srcId="{163911B8-DA45-45E5-9844-8E50ACAC911A}" destId="{90A98123-D996-419D-B76B-2B4D1F6AF0B3}" srcOrd="0" destOrd="0" presId="urn:microsoft.com/office/officeart/2005/8/layout/list1"/>
    <dgm:cxn modelId="{5EADD4DB-E276-401D-8BFC-3F78694CE7C1}" type="presOf" srcId="{E842E16B-D5FD-498B-8239-EC846B1CBA08}" destId="{12E1ABFC-C78C-4F0D-8E7D-F30F4EE457C2}" srcOrd="1" destOrd="0" presId="urn:microsoft.com/office/officeart/2005/8/layout/list1"/>
    <dgm:cxn modelId="{F96B1CF2-9D7F-4790-8A17-535B1BB09A7E}" type="presOf" srcId="{E842E16B-D5FD-498B-8239-EC846B1CBA08}" destId="{76AE0747-A560-4374-8A34-553A2591D7F7}" srcOrd="0" destOrd="0" presId="urn:microsoft.com/office/officeart/2005/8/layout/list1"/>
    <dgm:cxn modelId="{7C7B11F6-9AAF-41F4-9C09-E396D4DDCD9B}" srcId="{56E23DDB-1304-4D29-A169-A31BB30D3EE1}" destId="{C0E15827-DAEE-4C47-BE35-3C8E3F4341F6}" srcOrd="1" destOrd="0" parTransId="{7C73D7DE-D1BC-4D7C-BE46-EB037C87C825}" sibTransId="{B70D00FE-A276-4553-8FAD-241D97019377}"/>
    <dgm:cxn modelId="{7BA3F48D-2B99-47DA-B632-E70998E72F2C}" type="presParOf" srcId="{920395AC-91DC-4EE8-BC49-753B6FFDB977}" destId="{1FE0C8F6-CCDB-4892-A7A0-3E97613E3D4A}" srcOrd="0" destOrd="0" presId="urn:microsoft.com/office/officeart/2005/8/layout/list1"/>
    <dgm:cxn modelId="{C8147016-B3FE-47ED-B130-08FB995973BB}" type="presParOf" srcId="{1FE0C8F6-CCDB-4892-A7A0-3E97613E3D4A}" destId="{76AE0747-A560-4374-8A34-553A2591D7F7}" srcOrd="0" destOrd="0" presId="urn:microsoft.com/office/officeart/2005/8/layout/list1"/>
    <dgm:cxn modelId="{D4011A2A-2671-4578-AD91-5843F1FE0226}" type="presParOf" srcId="{1FE0C8F6-CCDB-4892-A7A0-3E97613E3D4A}" destId="{12E1ABFC-C78C-4F0D-8E7D-F30F4EE457C2}" srcOrd="1" destOrd="0" presId="urn:microsoft.com/office/officeart/2005/8/layout/list1"/>
    <dgm:cxn modelId="{92954CDD-848F-4C6B-ADF7-D1BD9F08F59D}" type="presParOf" srcId="{920395AC-91DC-4EE8-BC49-753B6FFDB977}" destId="{D52A9C77-B8FA-4A01-9F87-AC721D893948}" srcOrd="1" destOrd="0" presId="urn:microsoft.com/office/officeart/2005/8/layout/list1"/>
    <dgm:cxn modelId="{7C6E3C9A-8109-4854-BF3F-E1D6E8C8D54D}" type="presParOf" srcId="{920395AC-91DC-4EE8-BC49-753B6FFDB977}" destId="{15862389-6CB2-4FD9-A139-0DA95CF37254}" srcOrd="2" destOrd="0" presId="urn:microsoft.com/office/officeart/2005/8/layout/list1"/>
    <dgm:cxn modelId="{C05E827B-D9A2-4183-99C1-B17D97988DC4}" type="presParOf" srcId="{920395AC-91DC-4EE8-BC49-753B6FFDB977}" destId="{64BEF30E-20C2-40B4-9736-BE9B63EC1175}" srcOrd="3" destOrd="0" presId="urn:microsoft.com/office/officeart/2005/8/layout/list1"/>
    <dgm:cxn modelId="{2FF26D7B-37C8-42A8-AC4B-B9155BF6A99F}" type="presParOf" srcId="{920395AC-91DC-4EE8-BC49-753B6FFDB977}" destId="{988490AE-BE09-48A0-A395-6C3643A756F6}" srcOrd="4" destOrd="0" presId="urn:microsoft.com/office/officeart/2005/8/layout/list1"/>
    <dgm:cxn modelId="{1F3D67F7-7A5A-4355-81A0-6ADA4FD5ABED}" type="presParOf" srcId="{988490AE-BE09-48A0-A395-6C3643A756F6}" destId="{29E049D4-CE53-49EE-9D37-9E1CB075BC49}" srcOrd="0" destOrd="0" presId="urn:microsoft.com/office/officeart/2005/8/layout/list1"/>
    <dgm:cxn modelId="{46CA50EA-EB8F-42F5-92FE-62721777B047}" type="presParOf" srcId="{988490AE-BE09-48A0-A395-6C3643A756F6}" destId="{A68BC2BC-9001-48C3-8F1C-C51D7627644F}" srcOrd="1" destOrd="0" presId="urn:microsoft.com/office/officeart/2005/8/layout/list1"/>
    <dgm:cxn modelId="{E77519AC-3164-485E-801D-40D83BC4B94B}" type="presParOf" srcId="{920395AC-91DC-4EE8-BC49-753B6FFDB977}" destId="{B034BAA4-2F28-40A7-BBB9-92AFEBF736F8}" srcOrd="5" destOrd="0" presId="urn:microsoft.com/office/officeart/2005/8/layout/list1"/>
    <dgm:cxn modelId="{FA784E3F-A22B-4875-934D-D2BE64319EC1}" type="presParOf" srcId="{920395AC-91DC-4EE8-BC49-753B6FFDB977}" destId="{90A98123-D996-419D-B76B-2B4D1F6AF0B3}" srcOrd="6" destOrd="0" presId="urn:microsoft.com/office/officeart/2005/8/layout/list1"/>
    <dgm:cxn modelId="{BA43F824-7FB9-4BE4-8EC2-104E8C756A4A}" type="presParOf" srcId="{920395AC-91DC-4EE8-BC49-753B6FFDB977}" destId="{7F075120-7157-40E3-9EFB-F9D2A2FD8185}" srcOrd="7" destOrd="0" presId="urn:microsoft.com/office/officeart/2005/8/layout/list1"/>
    <dgm:cxn modelId="{CE55E8BB-BF86-41BB-84DE-6F23761BA01E}" type="presParOf" srcId="{920395AC-91DC-4EE8-BC49-753B6FFDB977}" destId="{6782B8BD-28FB-4521-811D-5E26CF5CE366}" srcOrd="8" destOrd="0" presId="urn:microsoft.com/office/officeart/2005/8/layout/list1"/>
    <dgm:cxn modelId="{93174A96-C8D5-4858-A796-13B74897FADD}" type="presParOf" srcId="{6782B8BD-28FB-4521-811D-5E26CF5CE366}" destId="{4EBB2C31-25E3-4CB7-A2A3-53271D63A6A1}" srcOrd="0" destOrd="0" presId="urn:microsoft.com/office/officeart/2005/8/layout/list1"/>
    <dgm:cxn modelId="{8657B38E-408A-4D57-A957-6FF9B2DDB19B}" type="presParOf" srcId="{6782B8BD-28FB-4521-811D-5E26CF5CE366}" destId="{5210B3BC-0093-4D6C-9C93-5925B2F0BF78}" srcOrd="1" destOrd="0" presId="urn:microsoft.com/office/officeart/2005/8/layout/list1"/>
    <dgm:cxn modelId="{A33570C5-C9C9-4D2F-996B-9F507A37AA6D}" type="presParOf" srcId="{920395AC-91DC-4EE8-BC49-753B6FFDB977}" destId="{897F5CCE-F4FB-4F37-AE7A-92952CC159EF}" srcOrd="9" destOrd="0" presId="urn:microsoft.com/office/officeart/2005/8/layout/list1"/>
    <dgm:cxn modelId="{DB7A6EAE-1CFF-4CD6-92FA-6BDDBD0EABF4}" type="presParOf" srcId="{920395AC-91DC-4EE8-BC49-753B6FFDB977}" destId="{892495FD-6C39-483C-90E9-5AC5389A00C3}" srcOrd="10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9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29EFAC0-0FCF-4D7C-AC84-FE3002B64BDE}" type="doc">
      <dgm:prSet loTypeId="urn:microsoft.com/office/officeart/2005/8/layout/vList4" loCatId="list" qsTypeId="urn:microsoft.com/office/officeart/2005/8/quickstyle/simple1" qsCatId="simple" csTypeId="urn:microsoft.com/office/officeart/2005/8/colors/accent5_1" csCatId="accent5" phldr="1"/>
      <dgm:spPr/>
      <dgm:t>
        <a:bodyPr/>
        <a:lstStyle/>
        <a:p>
          <a:endParaRPr lang="en-US"/>
        </a:p>
      </dgm:t>
    </dgm:pt>
    <dgm:pt modelId="{4FB2F2B6-8C35-443E-BBA4-76B3DB886AF6}">
      <dgm:prSet/>
      <dgm:spPr>
        <a:solidFill>
          <a:schemeClr val="accent5">
            <a:lumMod val="20000"/>
            <a:lumOff val="80000"/>
          </a:schemeClr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Partnered Massage therapy</a:t>
          </a:r>
        </a:p>
      </dgm:t>
    </dgm:pt>
    <dgm:pt modelId="{0E67977B-BF56-4687-993F-C9AA6FE2E7BE}" type="parTrans" cxnId="{BAFEDA2E-845B-48F9-832C-51A3E8E2CDD6}">
      <dgm:prSet/>
      <dgm:spPr/>
      <dgm:t>
        <a:bodyPr/>
        <a:lstStyle/>
        <a:p>
          <a:endParaRPr lang="en-US"/>
        </a:p>
      </dgm:t>
    </dgm:pt>
    <dgm:pt modelId="{08222939-8604-4331-8CDF-1B77CBE5FC87}" type="sibTrans" cxnId="{BAFEDA2E-845B-48F9-832C-51A3E8E2CDD6}">
      <dgm:prSet/>
      <dgm:spPr/>
      <dgm:t>
        <a:bodyPr/>
        <a:lstStyle/>
        <a:p>
          <a:endParaRPr lang="en-US"/>
        </a:p>
      </dgm:t>
    </dgm:pt>
    <dgm:pt modelId="{15EC82D4-86AA-4469-B593-99C37061A0CA}">
      <dgm:prSet/>
      <dgm:spPr>
        <a:solidFill>
          <a:schemeClr val="accent5">
            <a:lumMod val="20000"/>
            <a:lumOff val="80000"/>
          </a:schemeClr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Meditation &amp; Mindfulness</a:t>
          </a:r>
        </a:p>
      </dgm:t>
    </dgm:pt>
    <dgm:pt modelId="{1FB0DB04-FFD0-43A8-B176-216864D22EA4}" type="parTrans" cxnId="{9C4C84F1-7A68-4146-895C-988EB227C25B}">
      <dgm:prSet/>
      <dgm:spPr/>
      <dgm:t>
        <a:bodyPr/>
        <a:lstStyle/>
        <a:p>
          <a:endParaRPr lang="en-US"/>
        </a:p>
      </dgm:t>
    </dgm:pt>
    <dgm:pt modelId="{F413667F-3F55-456B-96FA-D2B2FF423D24}" type="sibTrans" cxnId="{9C4C84F1-7A68-4146-895C-988EB227C25B}">
      <dgm:prSet/>
      <dgm:spPr/>
      <dgm:t>
        <a:bodyPr/>
        <a:lstStyle/>
        <a:p>
          <a:endParaRPr lang="en-US"/>
        </a:p>
      </dgm:t>
    </dgm:pt>
    <dgm:pt modelId="{E8412525-3497-47BA-B407-4DFDC0C8F128}">
      <dgm:prSet/>
      <dgm:spPr>
        <a:solidFill>
          <a:schemeClr val="accent5">
            <a:lumMod val="20000"/>
            <a:lumOff val="80000"/>
          </a:schemeClr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Yoga </a:t>
          </a:r>
        </a:p>
      </dgm:t>
    </dgm:pt>
    <dgm:pt modelId="{8D36A691-44E2-45E6-A40B-0BE3EE929EED}" type="parTrans" cxnId="{DC6F1E3D-F193-481B-8E34-943A069A715F}">
      <dgm:prSet/>
      <dgm:spPr/>
      <dgm:t>
        <a:bodyPr/>
        <a:lstStyle/>
        <a:p>
          <a:endParaRPr lang="en-US"/>
        </a:p>
      </dgm:t>
    </dgm:pt>
    <dgm:pt modelId="{0AAD0CA5-E2C0-44B1-A1C3-8CCFB10B7986}" type="sibTrans" cxnId="{DC6F1E3D-F193-481B-8E34-943A069A715F}">
      <dgm:prSet/>
      <dgm:spPr/>
      <dgm:t>
        <a:bodyPr/>
        <a:lstStyle/>
        <a:p>
          <a:endParaRPr lang="en-US"/>
        </a:p>
      </dgm:t>
    </dgm:pt>
    <dgm:pt modelId="{FEF67B00-2B2B-4330-9607-33B4633BC8C6}">
      <dgm:prSet/>
      <dgm:spPr>
        <a:solidFill>
          <a:schemeClr val="accent5">
            <a:lumMod val="20000"/>
            <a:lumOff val="80000"/>
          </a:schemeClr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Surveys &amp; Interviews</a:t>
          </a:r>
        </a:p>
      </dgm:t>
    </dgm:pt>
    <dgm:pt modelId="{6AB3C0FB-F763-4B59-B17B-FA89635CFE18}" type="parTrans" cxnId="{766A55AC-4DB3-4B2C-AA68-9B044916A12F}">
      <dgm:prSet/>
      <dgm:spPr/>
      <dgm:t>
        <a:bodyPr/>
        <a:lstStyle/>
        <a:p>
          <a:endParaRPr lang="en-US"/>
        </a:p>
      </dgm:t>
    </dgm:pt>
    <dgm:pt modelId="{1E70DB5C-A988-4E3C-BBAB-D0163E5CD459}" type="sibTrans" cxnId="{766A55AC-4DB3-4B2C-AA68-9B044916A12F}">
      <dgm:prSet/>
      <dgm:spPr/>
      <dgm:t>
        <a:bodyPr/>
        <a:lstStyle/>
        <a:p>
          <a:endParaRPr lang="en-US"/>
        </a:p>
      </dgm:t>
    </dgm:pt>
    <dgm:pt modelId="{A5513A08-4857-4C03-BFEB-48C9FC112663}" type="pres">
      <dgm:prSet presAssocID="{429EFAC0-0FCF-4D7C-AC84-FE3002B64BDE}" presName="linear" presStyleCnt="0">
        <dgm:presLayoutVars>
          <dgm:dir/>
          <dgm:resizeHandles val="exact"/>
        </dgm:presLayoutVars>
      </dgm:prSet>
      <dgm:spPr/>
    </dgm:pt>
    <dgm:pt modelId="{8AC692C1-9716-44B2-A1A9-60398F803F89}" type="pres">
      <dgm:prSet presAssocID="{4FB2F2B6-8C35-443E-BBA4-76B3DB886AF6}" presName="comp" presStyleCnt="0"/>
      <dgm:spPr/>
    </dgm:pt>
    <dgm:pt modelId="{F382E0DA-1AA2-4413-B615-C5F50F09DCE3}" type="pres">
      <dgm:prSet presAssocID="{4FB2F2B6-8C35-443E-BBA4-76B3DB886AF6}" presName="box" presStyleLbl="node1" presStyleIdx="0" presStyleCnt="4"/>
      <dgm:spPr/>
    </dgm:pt>
    <dgm:pt modelId="{31B5C59F-86A1-4AA9-842E-EFCC3B71CEE6}" type="pres">
      <dgm:prSet presAssocID="{4FB2F2B6-8C35-443E-BBA4-76B3DB886AF6}" presName="img" presStyleLbl="fgImgPlace1" presStyleIdx="0" presStyleCnt="4"/>
      <dgm:spPr>
        <a:blipFill rotWithShape="1">
          <a:blip xmlns:r="http://schemas.openxmlformats.org/officeDocument/2006/relationships"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7000" r="-47000"/>
          </a:stretch>
        </a:blipFill>
      </dgm:spPr>
    </dgm:pt>
    <dgm:pt modelId="{D1CCC2C7-F6C5-441A-A9AE-3939B9A977A8}" type="pres">
      <dgm:prSet presAssocID="{4FB2F2B6-8C35-443E-BBA4-76B3DB886AF6}" presName="text" presStyleLbl="node1" presStyleIdx="0" presStyleCnt="4">
        <dgm:presLayoutVars>
          <dgm:bulletEnabled val="1"/>
        </dgm:presLayoutVars>
      </dgm:prSet>
      <dgm:spPr/>
    </dgm:pt>
    <dgm:pt modelId="{D4BFDAAF-04EC-456E-8800-AD8F84BA55E6}" type="pres">
      <dgm:prSet presAssocID="{08222939-8604-4331-8CDF-1B77CBE5FC87}" presName="spacer" presStyleCnt="0"/>
      <dgm:spPr/>
    </dgm:pt>
    <dgm:pt modelId="{082E8F8D-24AF-4682-907D-7A84C4C21099}" type="pres">
      <dgm:prSet presAssocID="{15EC82D4-86AA-4469-B593-99C37061A0CA}" presName="comp" presStyleCnt="0"/>
      <dgm:spPr/>
    </dgm:pt>
    <dgm:pt modelId="{3BE30352-517F-4A71-9A69-D2B9516C0C6E}" type="pres">
      <dgm:prSet presAssocID="{15EC82D4-86AA-4469-B593-99C37061A0CA}" presName="box" presStyleLbl="node1" presStyleIdx="1" presStyleCnt="4"/>
      <dgm:spPr/>
    </dgm:pt>
    <dgm:pt modelId="{8F8BA894-26DC-4A81-B9AC-9DF02BB0D062}" type="pres">
      <dgm:prSet presAssocID="{15EC82D4-86AA-4469-B593-99C37061A0CA}" presName="img" presStyleLbl="fgImgPlace1" presStyleIdx="1" presStyleCnt="4"/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3"/>
              </a:ext>
            </a:extLst>
          </a:blip>
          <a:srcRect/>
          <a:stretch>
            <a:fillRect l="-26000" r="-26000"/>
          </a:stretch>
        </a:blipFill>
      </dgm:spPr>
    </dgm:pt>
    <dgm:pt modelId="{4E6DE269-E0EE-48F6-9BE7-49C349416E9F}" type="pres">
      <dgm:prSet presAssocID="{15EC82D4-86AA-4469-B593-99C37061A0CA}" presName="text" presStyleLbl="node1" presStyleIdx="1" presStyleCnt="4">
        <dgm:presLayoutVars>
          <dgm:bulletEnabled val="1"/>
        </dgm:presLayoutVars>
      </dgm:prSet>
      <dgm:spPr/>
    </dgm:pt>
    <dgm:pt modelId="{C12E50F9-B98B-4849-ACCC-CE45A62D1685}" type="pres">
      <dgm:prSet presAssocID="{F413667F-3F55-456B-96FA-D2B2FF423D24}" presName="spacer" presStyleCnt="0"/>
      <dgm:spPr/>
    </dgm:pt>
    <dgm:pt modelId="{2A0BBA67-8ECA-4E83-8E0A-85FF5B8DDCD3}" type="pres">
      <dgm:prSet presAssocID="{E8412525-3497-47BA-B407-4DFDC0C8F128}" presName="comp" presStyleCnt="0"/>
      <dgm:spPr/>
    </dgm:pt>
    <dgm:pt modelId="{AA23DB44-841F-4F87-829D-74869DAABB73}" type="pres">
      <dgm:prSet presAssocID="{E8412525-3497-47BA-B407-4DFDC0C8F128}" presName="box" presStyleLbl="node1" presStyleIdx="2" presStyleCnt="4"/>
      <dgm:spPr/>
    </dgm:pt>
    <dgm:pt modelId="{8DE41113-3E88-4169-94EE-0B02771A78FE}" type="pres">
      <dgm:prSet presAssocID="{E8412525-3497-47BA-B407-4DFDC0C8F128}" presName="img" presStyleLbl="fgImgPlace1" presStyleIdx="2" presStyleCnt="4"/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5"/>
              </a:ext>
            </a:extLst>
          </a:blip>
          <a:srcRect/>
          <a:stretch>
            <a:fillRect l="-41000" r="-41000"/>
          </a:stretch>
        </a:blipFill>
      </dgm:spPr>
    </dgm:pt>
    <dgm:pt modelId="{F3F41FFC-C834-413D-AF40-DA166A2E4BAF}" type="pres">
      <dgm:prSet presAssocID="{E8412525-3497-47BA-B407-4DFDC0C8F128}" presName="text" presStyleLbl="node1" presStyleIdx="2" presStyleCnt="4">
        <dgm:presLayoutVars>
          <dgm:bulletEnabled val="1"/>
        </dgm:presLayoutVars>
      </dgm:prSet>
      <dgm:spPr/>
    </dgm:pt>
    <dgm:pt modelId="{75923A7A-BFBE-4D31-8832-CB82B1551B62}" type="pres">
      <dgm:prSet presAssocID="{0AAD0CA5-E2C0-44B1-A1C3-8CCFB10B7986}" presName="spacer" presStyleCnt="0"/>
      <dgm:spPr/>
    </dgm:pt>
    <dgm:pt modelId="{C0AB9420-7CD5-4911-8AB2-3344987E49A1}" type="pres">
      <dgm:prSet presAssocID="{FEF67B00-2B2B-4330-9607-33B4633BC8C6}" presName="comp" presStyleCnt="0"/>
      <dgm:spPr/>
    </dgm:pt>
    <dgm:pt modelId="{91CEF984-2E7F-4E2B-A673-E7F007AFF226}" type="pres">
      <dgm:prSet presAssocID="{FEF67B00-2B2B-4330-9607-33B4633BC8C6}" presName="box" presStyleLbl="node1" presStyleIdx="3" presStyleCnt="4"/>
      <dgm:spPr/>
    </dgm:pt>
    <dgm:pt modelId="{F071D144-03F9-45E9-B09E-B476175256F1}" type="pres">
      <dgm:prSet presAssocID="{FEF67B00-2B2B-4330-9607-33B4633BC8C6}" presName="img" presStyleLbl="fgImgPlace1" presStyleIdx="3" presStyleCnt="4"/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7"/>
              </a:ext>
            </a:extLst>
          </a:blip>
          <a:srcRect/>
          <a:stretch>
            <a:fillRect l="-18000" r="-18000"/>
          </a:stretch>
        </a:blipFill>
      </dgm:spPr>
    </dgm:pt>
    <dgm:pt modelId="{AE1051D2-CC2E-4EE5-BB73-197D0E1B87B7}" type="pres">
      <dgm:prSet presAssocID="{FEF67B00-2B2B-4330-9607-33B4633BC8C6}" presName="text" presStyleLbl="node1" presStyleIdx="3" presStyleCnt="4">
        <dgm:presLayoutVars>
          <dgm:bulletEnabled val="1"/>
        </dgm:presLayoutVars>
      </dgm:prSet>
      <dgm:spPr/>
    </dgm:pt>
  </dgm:ptLst>
  <dgm:cxnLst>
    <dgm:cxn modelId="{3BCE8C1D-E33D-4FDC-A5F7-96667958D644}" type="presOf" srcId="{4FB2F2B6-8C35-443E-BBA4-76B3DB886AF6}" destId="{F382E0DA-1AA2-4413-B615-C5F50F09DCE3}" srcOrd="0" destOrd="0" presId="urn:microsoft.com/office/officeart/2005/8/layout/vList4"/>
    <dgm:cxn modelId="{97D0F72B-5A2B-41EE-B8EE-150DF2BC3EFB}" type="presOf" srcId="{15EC82D4-86AA-4469-B593-99C37061A0CA}" destId="{3BE30352-517F-4A71-9A69-D2B9516C0C6E}" srcOrd="0" destOrd="0" presId="urn:microsoft.com/office/officeart/2005/8/layout/vList4"/>
    <dgm:cxn modelId="{BAFEDA2E-845B-48F9-832C-51A3E8E2CDD6}" srcId="{429EFAC0-0FCF-4D7C-AC84-FE3002B64BDE}" destId="{4FB2F2B6-8C35-443E-BBA4-76B3DB886AF6}" srcOrd="0" destOrd="0" parTransId="{0E67977B-BF56-4687-993F-C9AA6FE2E7BE}" sibTransId="{08222939-8604-4331-8CDF-1B77CBE5FC87}"/>
    <dgm:cxn modelId="{778BAA36-E818-4EC1-81A6-233B83100E99}" type="presOf" srcId="{E8412525-3497-47BA-B407-4DFDC0C8F128}" destId="{F3F41FFC-C834-413D-AF40-DA166A2E4BAF}" srcOrd="1" destOrd="0" presId="urn:microsoft.com/office/officeart/2005/8/layout/vList4"/>
    <dgm:cxn modelId="{DC6F1E3D-F193-481B-8E34-943A069A715F}" srcId="{429EFAC0-0FCF-4D7C-AC84-FE3002B64BDE}" destId="{E8412525-3497-47BA-B407-4DFDC0C8F128}" srcOrd="2" destOrd="0" parTransId="{8D36A691-44E2-45E6-A40B-0BE3EE929EED}" sibTransId="{0AAD0CA5-E2C0-44B1-A1C3-8CCFB10B7986}"/>
    <dgm:cxn modelId="{AD9BE841-78EC-48EB-9A26-61DACC48EDBE}" type="presOf" srcId="{429EFAC0-0FCF-4D7C-AC84-FE3002B64BDE}" destId="{A5513A08-4857-4C03-BFEB-48C9FC112663}" srcOrd="0" destOrd="0" presId="urn:microsoft.com/office/officeart/2005/8/layout/vList4"/>
    <dgm:cxn modelId="{B7CE284A-3622-43D8-9B4B-421420E6DB60}" type="presOf" srcId="{FEF67B00-2B2B-4330-9607-33B4633BC8C6}" destId="{AE1051D2-CC2E-4EE5-BB73-197D0E1B87B7}" srcOrd="1" destOrd="0" presId="urn:microsoft.com/office/officeart/2005/8/layout/vList4"/>
    <dgm:cxn modelId="{AE0CA352-72DF-4D88-BD51-9609767975D5}" type="presOf" srcId="{E8412525-3497-47BA-B407-4DFDC0C8F128}" destId="{AA23DB44-841F-4F87-829D-74869DAABB73}" srcOrd="0" destOrd="0" presId="urn:microsoft.com/office/officeart/2005/8/layout/vList4"/>
    <dgm:cxn modelId="{766A55AC-4DB3-4B2C-AA68-9B044916A12F}" srcId="{429EFAC0-0FCF-4D7C-AC84-FE3002B64BDE}" destId="{FEF67B00-2B2B-4330-9607-33B4633BC8C6}" srcOrd="3" destOrd="0" parTransId="{6AB3C0FB-F763-4B59-B17B-FA89635CFE18}" sibTransId="{1E70DB5C-A988-4E3C-BBAB-D0163E5CD459}"/>
    <dgm:cxn modelId="{B77108C3-7BDE-4078-B931-73835658A276}" type="presOf" srcId="{FEF67B00-2B2B-4330-9607-33B4633BC8C6}" destId="{91CEF984-2E7F-4E2B-A673-E7F007AFF226}" srcOrd="0" destOrd="0" presId="urn:microsoft.com/office/officeart/2005/8/layout/vList4"/>
    <dgm:cxn modelId="{A8B2A2D0-0050-4D37-888E-FDC3F1C614D8}" type="presOf" srcId="{15EC82D4-86AA-4469-B593-99C37061A0CA}" destId="{4E6DE269-E0EE-48F6-9BE7-49C349416E9F}" srcOrd="1" destOrd="0" presId="urn:microsoft.com/office/officeart/2005/8/layout/vList4"/>
    <dgm:cxn modelId="{9C4C84F1-7A68-4146-895C-988EB227C25B}" srcId="{429EFAC0-0FCF-4D7C-AC84-FE3002B64BDE}" destId="{15EC82D4-86AA-4469-B593-99C37061A0CA}" srcOrd="1" destOrd="0" parTransId="{1FB0DB04-FFD0-43A8-B176-216864D22EA4}" sibTransId="{F413667F-3F55-456B-96FA-D2B2FF423D24}"/>
    <dgm:cxn modelId="{371C0CF2-CAAC-4712-BE6E-D70864A6F891}" type="presOf" srcId="{4FB2F2B6-8C35-443E-BBA4-76B3DB886AF6}" destId="{D1CCC2C7-F6C5-441A-A9AE-3939B9A977A8}" srcOrd="1" destOrd="0" presId="urn:microsoft.com/office/officeart/2005/8/layout/vList4"/>
    <dgm:cxn modelId="{19120054-6082-46FA-B40A-E6EB1245587C}" type="presParOf" srcId="{A5513A08-4857-4C03-BFEB-48C9FC112663}" destId="{8AC692C1-9716-44B2-A1A9-60398F803F89}" srcOrd="0" destOrd="0" presId="urn:microsoft.com/office/officeart/2005/8/layout/vList4"/>
    <dgm:cxn modelId="{6CF3AE0D-B132-40A5-B906-09426D7E9D93}" type="presParOf" srcId="{8AC692C1-9716-44B2-A1A9-60398F803F89}" destId="{F382E0DA-1AA2-4413-B615-C5F50F09DCE3}" srcOrd="0" destOrd="0" presId="urn:microsoft.com/office/officeart/2005/8/layout/vList4"/>
    <dgm:cxn modelId="{CE507067-6F55-464A-9E20-11C868785B3E}" type="presParOf" srcId="{8AC692C1-9716-44B2-A1A9-60398F803F89}" destId="{31B5C59F-86A1-4AA9-842E-EFCC3B71CEE6}" srcOrd="1" destOrd="0" presId="urn:microsoft.com/office/officeart/2005/8/layout/vList4"/>
    <dgm:cxn modelId="{4499CAB2-CD55-40CC-B97C-2478B5D54C1C}" type="presParOf" srcId="{8AC692C1-9716-44B2-A1A9-60398F803F89}" destId="{D1CCC2C7-F6C5-441A-A9AE-3939B9A977A8}" srcOrd="2" destOrd="0" presId="urn:microsoft.com/office/officeart/2005/8/layout/vList4"/>
    <dgm:cxn modelId="{3C4444CB-BBE0-4904-BF25-B1BB71D24FFD}" type="presParOf" srcId="{A5513A08-4857-4C03-BFEB-48C9FC112663}" destId="{D4BFDAAF-04EC-456E-8800-AD8F84BA55E6}" srcOrd="1" destOrd="0" presId="urn:microsoft.com/office/officeart/2005/8/layout/vList4"/>
    <dgm:cxn modelId="{C5F4E0D3-93F2-4BD0-953A-34645347087D}" type="presParOf" srcId="{A5513A08-4857-4C03-BFEB-48C9FC112663}" destId="{082E8F8D-24AF-4682-907D-7A84C4C21099}" srcOrd="2" destOrd="0" presId="urn:microsoft.com/office/officeart/2005/8/layout/vList4"/>
    <dgm:cxn modelId="{0501FB1E-3867-49C0-9972-3A42B819E4CC}" type="presParOf" srcId="{082E8F8D-24AF-4682-907D-7A84C4C21099}" destId="{3BE30352-517F-4A71-9A69-D2B9516C0C6E}" srcOrd="0" destOrd="0" presId="urn:microsoft.com/office/officeart/2005/8/layout/vList4"/>
    <dgm:cxn modelId="{80685134-DB7C-43D8-8F37-DFC63971939B}" type="presParOf" srcId="{082E8F8D-24AF-4682-907D-7A84C4C21099}" destId="{8F8BA894-26DC-4A81-B9AC-9DF02BB0D062}" srcOrd="1" destOrd="0" presId="urn:microsoft.com/office/officeart/2005/8/layout/vList4"/>
    <dgm:cxn modelId="{B63B3E8B-57F9-4A91-8540-83D5B027E1A6}" type="presParOf" srcId="{082E8F8D-24AF-4682-907D-7A84C4C21099}" destId="{4E6DE269-E0EE-48F6-9BE7-49C349416E9F}" srcOrd="2" destOrd="0" presId="urn:microsoft.com/office/officeart/2005/8/layout/vList4"/>
    <dgm:cxn modelId="{C74D9A29-E166-4915-9758-2593BCAA1BFC}" type="presParOf" srcId="{A5513A08-4857-4C03-BFEB-48C9FC112663}" destId="{C12E50F9-B98B-4849-ACCC-CE45A62D1685}" srcOrd="3" destOrd="0" presId="urn:microsoft.com/office/officeart/2005/8/layout/vList4"/>
    <dgm:cxn modelId="{9D544396-8079-4B7A-9043-B8FF8EF66CA9}" type="presParOf" srcId="{A5513A08-4857-4C03-BFEB-48C9FC112663}" destId="{2A0BBA67-8ECA-4E83-8E0A-85FF5B8DDCD3}" srcOrd="4" destOrd="0" presId="urn:microsoft.com/office/officeart/2005/8/layout/vList4"/>
    <dgm:cxn modelId="{17861AA8-01E8-4710-BEBD-220CF47FCA6C}" type="presParOf" srcId="{2A0BBA67-8ECA-4E83-8E0A-85FF5B8DDCD3}" destId="{AA23DB44-841F-4F87-829D-74869DAABB73}" srcOrd="0" destOrd="0" presId="urn:microsoft.com/office/officeart/2005/8/layout/vList4"/>
    <dgm:cxn modelId="{D780BCF3-B541-4EB6-A8A1-17C139A60EDC}" type="presParOf" srcId="{2A0BBA67-8ECA-4E83-8E0A-85FF5B8DDCD3}" destId="{8DE41113-3E88-4169-94EE-0B02771A78FE}" srcOrd="1" destOrd="0" presId="urn:microsoft.com/office/officeart/2005/8/layout/vList4"/>
    <dgm:cxn modelId="{6E8558F7-080A-48A7-A999-7A7F2F8F7F89}" type="presParOf" srcId="{2A0BBA67-8ECA-4E83-8E0A-85FF5B8DDCD3}" destId="{F3F41FFC-C834-413D-AF40-DA166A2E4BAF}" srcOrd="2" destOrd="0" presId="urn:microsoft.com/office/officeart/2005/8/layout/vList4"/>
    <dgm:cxn modelId="{A4564CB5-B11A-4B31-B582-DD641FBA44EF}" type="presParOf" srcId="{A5513A08-4857-4C03-BFEB-48C9FC112663}" destId="{75923A7A-BFBE-4D31-8832-CB82B1551B62}" srcOrd="5" destOrd="0" presId="urn:microsoft.com/office/officeart/2005/8/layout/vList4"/>
    <dgm:cxn modelId="{C39915A2-4D68-44F7-B588-B392178F87F2}" type="presParOf" srcId="{A5513A08-4857-4C03-BFEB-48C9FC112663}" destId="{C0AB9420-7CD5-4911-8AB2-3344987E49A1}" srcOrd="6" destOrd="0" presId="urn:microsoft.com/office/officeart/2005/8/layout/vList4"/>
    <dgm:cxn modelId="{F92076D2-F088-440B-B3C2-EED125C0B568}" type="presParOf" srcId="{C0AB9420-7CD5-4911-8AB2-3344987E49A1}" destId="{91CEF984-2E7F-4E2B-A673-E7F007AFF226}" srcOrd="0" destOrd="0" presId="urn:microsoft.com/office/officeart/2005/8/layout/vList4"/>
    <dgm:cxn modelId="{FE03E16F-DB03-4B3A-9403-53AD264EB152}" type="presParOf" srcId="{C0AB9420-7CD5-4911-8AB2-3344987E49A1}" destId="{F071D144-03F9-45E9-B09E-B476175256F1}" srcOrd="1" destOrd="0" presId="urn:microsoft.com/office/officeart/2005/8/layout/vList4"/>
    <dgm:cxn modelId="{F9311A22-C98D-4D9D-86B4-A7C563DD2DC9}" type="presParOf" srcId="{C0AB9420-7CD5-4911-8AB2-3344987E49A1}" destId="{AE1051D2-CC2E-4EE5-BB73-197D0E1B87B7}" srcOrd="2" destOrd="0" presId="urn:microsoft.com/office/officeart/2005/8/layout/vList4"/>
  </dgm:cxnLst>
  <dgm:bg/>
  <dgm:whole/>
  <dgm:extLst>
    <a:ext uri="http://schemas.microsoft.com/office/drawing/2008/diagram">
      <dsp:dataModelExt xmlns:dsp="http://schemas.microsoft.com/office/drawing/2008/diagram" relId="rId14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5862389-6CB2-4FD9-A139-0DA95CF37254}">
      <dsp:nvSpPr>
        <dsp:cNvPr id="0" name=""/>
        <dsp:cNvSpPr/>
      </dsp:nvSpPr>
      <dsp:spPr>
        <a:xfrm>
          <a:off x="0" y="314550"/>
          <a:ext cx="2984080" cy="16443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31598" tIns="374904" rIns="231598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18+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Veteran with chronic pain &amp; PTSD.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Partner who is willing to join. (Spouse, significant other, caregiver, family member etc.)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Access to internet or mobile application</a:t>
          </a:r>
        </a:p>
      </dsp:txBody>
      <dsp:txXfrm>
        <a:off x="0" y="314550"/>
        <a:ext cx="2984080" cy="1644300"/>
      </dsp:txXfrm>
    </dsp:sp>
    <dsp:sp modelId="{12E1ABFC-C78C-4F0D-8E7D-F30F4EE457C2}">
      <dsp:nvSpPr>
        <dsp:cNvPr id="0" name=""/>
        <dsp:cNvSpPr/>
      </dsp:nvSpPr>
      <dsp:spPr>
        <a:xfrm>
          <a:off x="149204" y="48870"/>
          <a:ext cx="2088856" cy="531360"/>
        </a:xfrm>
        <a:prstGeom prst="roundRect">
          <a:avLst/>
        </a:prstGeom>
        <a:gradFill rotWithShape="0">
          <a:gsLst>
            <a:gs pos="0">
              <a:schemeClr val="accent5">
                <a:hueOff val="0"/>
                <a:satOff val="0"/>
                <a:lumOff val="0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5">
                <a:hueOff val="0"/>
                <a:satOff val="0"/>
                <a:lumOff val="0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5">
                <a:hueOff val="0"/>
                <a:satOff val="0"/>
                <a:lumOff val="0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8954" tIns="0" rIns="78954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Eligibility: </a:t>
          </a:r>
          <a:endParaRPr lang="en-US" sz="1400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5143" y="74809"/>
        <a:ext cx="2036978" cy="479482"/>
      </dsp:txXfrm>
    </dsp:sp>
    <dsp:sp modelId="{90A98123-D996-419D-B76B-2B4D1F6AF0B3}">
      <dsp:nvSpPr>
        <dsp:cNvPr id="0" name=""/>
        <dsp:cNvSpPr/>
      </dsp:nvSpPr>
      <dsp:spPr>
        <a:xfrm>
          <a:off x="0" y="2321730"/>
          <a:ext cx="2984080" cy="779625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31598" tIns="374904" rIns="231598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Online using mobile phone and/or web</a:t>
          </a:r>
        </a:p>
      </dsp:txBody>
      <dsp:txXfrm>
        <a:off x="0" y="2321730"/>
        <a:ext cx="2984080" cy="779625"/>
      </dsp:txXfrm>
    </dsp:sp>
    <dsp:sp modelId="{A68BC2BC-9001-48C3-8F1C-C51D7627644F}">
      <dsp:nvSpPr>
        <dsp:cNvPr id="0" name=""/>
        <dsp:cNvSpPr/>
      </dsp:nvSpPr>
      <dsp:spPr>
        <a:xfrm>
          <a:off x="149204" y="2056050"/>
          <a:ext cx="2088856" cy="531360"/>
        </a:xfrm>
        <a:prstGeom prst="roundRect">
          <a:avLst/>
        </a:prstGeom>
        <a:gradFill rotWithShape="0">
          <a:gsLst>
            <a:gs pos="0">
              <a:schemeClr val="accent5">
                <a:hueOff val="0"/>
                <a:satOff val="0"/>
                <a:lumOff val="0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5">
                <a:hueOff val="0"/>
                <a:satOff val="0"/>
                <a:lumOff val="0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5">
                <a:hueOff val="0"/>
                <a:satOff val="0"/>
                <a:lumOff val="0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8954" tIns="0" rIns="78954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Where does the study take place?</a:t>
          </a:r>
          <a:endParaRPr lang="en-US" sz="1400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5143" y="2081989"/>
        <a:ext cx="2036978" cy="479482"/>
      </dsp:txXfrm>
    </dsp:sp>
    <dsp:sp modelId="{892495FD-6C39-483C-90E9-5AC5389A00C3}">
      <dsp:nvSpPr>
        <dsp:cNvPr id="0" name=""/>
        <dsp:cNvSpPr/>
      </dsp:nvSpPr>
      <dsp:spPr>
        <a:xfrm>
          <a:off x="0" y="3464235"/>
          <a:ext cx="2984080" cy="127575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31598" tIns="374904" rIns="231598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b="0" kern="1200" dirty="0">
              <a:latin typeface="Arial" panose="020B0604020202020204" pitchFamily="34" charset="0"/>
              <a:cs typeface="Arial" panose="020B0604020202020204" pitchFamily="34" charset="0"/>
            </a:rPr>
            <a:t>Reduce pain, anxiety &amp; stress, promote individual well-being &amp; improve quality of relationship</a:t>
          </a:r>
          <a:endParaRPr lang="en-US" sz="1200" b="1" kern="1200" dirty="0">
            <a:latin typeface="Arial" panose="020B0604020202020204" pitchFamily="34" charset="0"/>
            <a:cs typeface="Arial" panose="020B0604020202020204" pitchFamily="34" charset="0"/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Reimbursement for time &amp; effort, up to $140. </a:t>
          </a:r>
          <a:endParaRPr lang="en-US" sz="12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0" y="3464235"/>
        <a:ext cx="2984080" cy="1275750"/>
      </dsp:txXfrm>
    </dsp:sp>
    <dsp:sp modelId="{5210B3BC-0093-4D6C-9C93-5925B2F0BF78}">
      <dsp:nvSpPr>
        <dsp:cNvPr id="0" name=""/>
        <dsp:cNvSpPr/>
      </dsp:nvSpPr>
      <dsp:spPr>
        <a:xfrm>
          <a:off x="151322" y="3200686"/>
          <a:ext cx="2088856" cy="531360"/>
        </a:xfrm>
        <a:prstGeom prst="roundRect">
          <a:avLst/>
        </a:prstGeom>
        <a:gradFill rotWithShape="0">
          <a:gsLst>
            <a:gs pos="0">
              <a:schemeClr val="accent5">
                <a:hueOff val="0"/>
                <a:satOff val="0"/>
                <a:lumOff val="0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5">
                <a:hueOff val="0"/>
                <a:satOff val="0"/>
                <a:lumOff val="0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5">
                <a:hueOff val="0"/>
                <a:satOff val="0"/>
                <a:lumOff val="0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8954" tIns="0" rIns="78954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ossible Benefits:</a:t>
          </a:r>
        </a:p>
      </dsp:txBody>
      <dsp:txXfrm>
        <a:off x="177261" y="3226625"/>
        <a:ext cx="2036978" cy="479482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382E0DA-1AA2-4413-B615-C5F50F09DCE3}">
      <dsp:nvSpPr>
        <dsp:cNvPr id="0" name=""/>
        <dsp:cNvSpPr/>
      </dsp:nvSpPr>
      <dsp:spPr>
        <a:xfrm>
          <a:off x="0" y="0"/>
          <a:ext cx="2798967" cy="663217"/>
        </a:xfrm>
        <a:prstGeom prst="roundRect">
          <a:avLst>
            <a:gd name="adj" fmla="val 10000"/>
          </a:avLst>
        </a:prstGeom>
        <a:solidFill>
          <a:schemeClr val="accent5">
            <a:lumMod val="20000"/>
            <a:lumOff val="80000"/>
          </a:schemeClr>
        </a:solid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>
              <a:latin typeface="Arial" panose="020B0604020202020204" pitchFamily="34" charset="0"/>
              <a:cs typeface="Arial" panose="020B0604020202020204" pitchFamily="34" charset="0"/>
            </a:rPr>
            <a:t>Partnered Massage therapy</a:t>
          </a:r>
        </a:p>
      </dsp:txBody>
      <dsp:txXfrm>
        <a:off x="626115" y="0"/>
        <a:ext cx="2172851" cy="663217"/>
      </dsp:txXfrm>
    </dsp:sp>
    <dsp:sp modelId="{31B5C59F-86A1-4AA9-842E-EFCC3B71CEE6}">
      <dsp:nvSpPr>
        <dsp:cNvPr id="0" name=""/>
        <dsp:cNvSpPr/>
      </dsp:nvSpPr>
      <dsp:spPr>
        <a:xfrm>
          <a:off x="66321" y="66321"/>
          <a:ext cx="559793" cy="530574"/>
        </a:xfrm>
        <a:prstGeom prst="roundRect">
          <a:avLst>
            <a:gd name="adj" fmla="val 10000"/>
          </a:avLst>
        </a:prstGeom>
        <a:blipFill rotWithShape="1">
          <a:blip xmlns:r="http://schemas.openxmlformats.org/officeDocument/2006/relationships"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7000" r="-47000"/>
          </a:stretch>
        </a:blip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BE30352-517F-4A71-9A69-D2B9516C0C6E}">
      <dsp:nvSpPr>
        <dsp:cNvPr id="0" name=""/>
        <dsp:cNvSpPr/>
      </dsp:nvSpPr>
      <dsp:spPr>
        <a:xfrm>
          <a:off x="0" y="729539"/>
          <a:ext cx="2798967" cy="663217"/>
        </a:xfrm>
        <a:prstGeom prst="roundRect">
          <a:avLst>
            <a:gd name="adj" fmla="val 10000"/>
          </a:avLst>
        </a:prstGeom>
        <a:solidFill>
          <a:schemeClr val="accent5">
            <a:lumMod val="20000"/>
            <a:lumOff val="80000"/>
          </a:schemeClr>
        </a:solid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>
              <a:latin typeface="Arial" panose="020B0604020202020204" pitchFamily="34" charset="0"/>
              <a:cs typeface="Arial" panose="020B0604020202020204" pitchFamily="34" charset="0"/>
            </a:rPr>
            <a:t>Meditation &amp; Mindfulness</a:t>
          </a:r>
        </a:p>
      </dsp:txBody>
      <dsp:txXfrm>
        <a:off x="626115" y="729539"/>
        <a:ext cx="2172851" cy="663217"/>
      </dsp:txXfrm>
    </dsp:sp>
    <dsp:sp modelId="{8F8BA894-26DC-4A81-B9AC-9DF02BB0D062}">
      <dsp:nvSpPr>
        <dsp:cNvPr id="0" name=""/>
        <dsp:cNvSpPr/>
      </dsp:nvSpPr>
      <dsp:spPr>
        <a:xfrm>
          <a:off x="66321" y="795861"/>
          <a:ext cx="559793" cy="530574"/>
        </a:xfrm>
        <a:prstGeom prst="roundRect">
          <a:avLst>
            <a:gd name="adj" fmla="val 10000"/>
          </a:avLst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3"/>
              </a:ext>
            </a:extLst>
          </a:blip>
          <a:srcRect/>
          <a:stretch>
            <a:fillRect l="-26000" r="-26000"/>
          </a:stretch>
        </a:blip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A23DB44-841F-4F87-829D-74869DAABB73}">
      <dsp:nvSpPr>
        <dsp:cNvPr id="0" name=""/>
        <dsp:cNvSpPr/>
      </dsp:nvSpPr>
      <dsp:spPr>
        <a:xfrm>
          <a:off x="0" y="1459078"/>
          <a:ext cx="2798967" cy="663217"/>
        </a:xfrm>
        <a:prstGeom prst="roundRect">
          <a:avLst>
            <a:gd name="adj" fmla="val 10000"/>
          </a:avLst>
        </a:prstGeom>
        <a:solidFill>
          <a:schemeClr val="accent5">
            <a:lumMod val="20000"/>
            <a:lumOff val="80000"/>
          </a:schemeClr>
        </a:solid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>
              <a:latin typeface="Arial" panose="020B0604020202020204" pitchFamily="34" charset="0"/>
              <a:cs typeface="Arial" panose="020B0604020202020204" pitchFamily="34" charset="0"/>
            </a:rPr>
            <a:t>Yoga </a:t>
          </a:r>
        </a:p>
      </dsp:txBody>
      <dsp:txXfrm>
        <a:off x="626115" y="1459078"/>
        <a:ext cx="2172851" cy="663217"/>
      </dsp:txXfrm>
    </dsp:sp>
    <dsp:sp modelId="{8DE41113-3E88-4169-94EE-0B02771A78FE}">
      <dsp:nvSpPr>
        <dsp:cNvPr id="0" name=""/>
        <dsp:cNvSpPr/>
      </dsp:nvSpPr>
      <dsp:spPr>
        <a:xfrm>
          <a:off x="66321" y="1525400"/>
          <a:ext cx="559793" cy="530574"/>
        </a:xfrm>
        <a:prstGeom prst="roundRect">
          <a:avLst>
            <a:gd name="adj" fmla="val 10000"/>
          </a:avLst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5"/>
              </a:ext>
            </a:extLst>
          </a:blip>
          <a:srcRect/>
          <a:stretch>
            <a:fillRect l="-41000" r="-41000"/>
          </a:stretch>
        </a:blip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1CEF984-2E7F-4E2B-A673-E7F007AFF226}">
      <dsp:nvSpPr>
        <dsp:cNvPr id="0" name=""/>
        <dsp:cNvSpPr/>
      </dsp:nvSpPr>
      <dsp:spPr>
        <a:xfrm>
          <a:off x="0" y="2188618"/>
          <a:ext cx="2798967" cy="663217"/>
        </a:xfrm>
        <a:prstGeom prst="roundRect">
          <a:avLst>
            <a:gd name="adj" fmla="val 10000"/>
          </a:avLst>
        </a:prstGeom>
        <a:solidFill>
          <a:schemeClr val="accent5">
            <a:lumMod val="20000"/>
            <a:lumOff val="80000"/>
          </a:schemeClr>
        </a:solid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>
              <a:latin typeface="Arial" panose="020B0604020202020204" pitchFamily="34" charset="0"/>
              <a:cs typeface="Arial" panose="020B0604020202020204" pitchFamily="34" charset="0"/>
            </a:rPr>
            <a:t>Surveys &amp; Interviews</a:t>
          </a:r>
        </a:p>
      </dsp:txBody>
      <dsp:txXfrm>
        <a:off x="626115" y="2188618"/>
        <a:ext cx="2172851" cy="663217"/>
      </dsp:txXfrm>
    </dsp:sp>
    <dsp:sp modelId="{F071D144-03F9-45E9-B09E-B476175256F1}">
      <dsp:nvSpPr>
        <dsp:cNvPr id="0" name=""/>
        <dsp:cNvSpPr/>
      </dsp:nvSpPr>
      <dsp:spPr>
        <a:xfrm>
          <a:off x="66321" y="2254940"/>
          <a:ext cx="559793" cy="530574"/>
        </a:xfrm>
        <a:prstGeom prst="roundRect">
          <a:avLst>
            <a:gd name="adj" fmla="val 10000"/>
          </a:avLst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7"/>
              </a:ext>
            </a:extLst>
          </a:blip>
          <a:srcRect/>
          <a:stretch>
            <a:fillRect l="-18000" r="-18000"/>
          </a:stretch>
        </a:blipFill>
        <a:ln w="12700" cap="flat" cmpd="sng" algn="ctr">
          <a:solidFill>
            <a:schemeClr val="accent5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List4">
  <dgm:title val=""/>
  <dgm:desc val=""/>
  <dgm:catLst>
    <dgm:cat type="list" pri="13000"/>
    <dgm:cat type="picture" pri="26000"/>
    <dgm:cat type="pictureconvert" pri="26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  <dgm:cxn modelId="33" srcId="3" destId="31" srcOrd="0" destOrd="0"/>
        <dgm:cxn modelId="34" srcId="3" destId="32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resizeHandles val="exact"/>
    </dgm:varLst>
    <dgm:alg type="lin">
      <dgm:param type="linDir" val="fromT"/>
      <dgm:param type="vertAlign" val="t"/>
    </dgm:alg>
    <dgm:shape xmlns:r="http://schemas.openxmlformats.org/officeDocument/2006/relationships" r:blip="">
      <dgm:adjLst/>
    </dgm:shape>
    <dgm:presOf/>
    <dgm:constrLst>
      <dgm:constr type="w" for="ch" forName="comp" refType="w"/>
      <dgm:constr type="h" for="ch" forName="comp" refType="h"/>
      <dgm:constr type="h" for="ch" forName="spacer" refType="h" refFor="ch" refForName="comp" op="equ" fact="0.1"/>
      <dgm:constr type="primFontSz" for="des" forName="text" op="equ" val="65"/>
    </dgm:constrLst>
    <dgm:ruleLst/>
    <dgm:forEach name="Name0" axis="ch" ptType="node">
      <dgm:layoutNode name="comp" styleLbl="node1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h" for="ch" forName="box" refType="h"/>
              <dgm:constr type="w" for="ch" forName="box" refType="w"/>
              <dgm:constr type="w" for="ch" forName="img" refType="w" refFor="ch" refForName="box" fact="0.2"/>
              <dgm:constr type="h" for="ch" forName="img" refType="h" refFor="ch" refForName="box" fact="0.8"/>
              <dgm:constr type="t" for="ch" forName="img" refType="h" refFor="ch" refForName="box" fact="0.1"/>
              <dgm:constr type="l" for="ch" forName="img" refType="h" refFor="ch" refForName="box" fact="0.1"/>
              <dgm:constr type="h" for="ch" forName="text" refType="h"/>
              <dgm:constr type="l" for="ch" forName="text" refType="r" refFor="ch" refForName="img"/>
              <dgm:constr type="r" for="ch" forName="text" refType="w"/>
            </dgm:constrLst>
          </dgm:if>
          <dgm:else name="Name3">
            <dgm:constrLst>
              <dgm:constr type="h" for="ch" forName="box" refType="h"/>
              <dgm:constr type="w" for="ch" forName="box" refType="w"/>
              <dgm:constr type="w" for="ch" forName="img" refType="w" refFor="ch" refForName="box" fact="0.2"/>
              <dgm:constr type="h" for="ch" forName="img" refType="h" refFor="ch" refForName="box" fact="0.8"/>
              <dgm:constr type="t" for="ch" forName="img" refType="h" refFor="ch" refForName="box" fact="0.1"/>
              <dgm:constr type="r" for="ch" forName="img" refType="w" refFor="ch" refForName="box"/>
              <dgm:constr type="rOff" for="ch" forName="img" refType="h" refFor="ch" refForName="box" fact="-0.1"/>
              <dgm:constr type="h" for="ch" forName="text" refType="h"/>
              <dgm:constr type="r" for="ch" forName="text" refType="l" refFor="ch" refForName="img"/>
              <dgm:constr type="l" for="ch" forName="text"/>
            </dgm:constrLst>
          </dgm:else>
        </dgm:choose>
        <dgm:ruleLst/>
        <dgm:layoutNode name="box" styleLbl="node1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 axis="desOrSelf" ptType="node"/>
          <dgm:constrLst/>
          <dgm:ruleLst/>
        </dgm:layoutNode>
        <dgm:layoutNode name="img" styleLbl="fgImgPlace1">
          <dgm:alg type="sp"/>
          <dgm:shape xmlns:r="http://schemas.openxmlformats.org/officeDocument/2006/relationships" type="roundRect" r:blip="" blipPhldr="1">
            <dgm:adjLst>
              <dgm:adj idx="1" val="0.1"/>
            </dgm:adjLst>
          </dgm:shape>
          <dgm:presOf/>
          <dgm:constrLst/>
          <dgm:ruleLst/>
        </dgm:layoutNode>
        <dgm:layoutNode name="text">
          <dgm:varLst>
            <dgm:bulletEnabled val="1"/>
          </dgm:varLst>
          <dgm:alg type="tx">
            <dgm:param type="parTxLTRAlign" val="l"/>
            <dgm:param type="parTxRTLAlign" val="r"/>
          </dgm:alg>
          <dgm:shape xmlns:r="http://schemas.openxmlformats.org/officeDocument/2006/relationships" type="rect" r:blip="" hideGeom="1">
            <dgm:adjLst/>
          </dgm:shape>
          <dgm:presOf axis="desOrSelf" ptType="node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</dgm:layoutNode>
      <dgm:forEach name="Name4" axis="followSib" ptType="sibTrans" cnt="1">
        <dgm:layoutNode name="spacer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3d1">
  <dgm:title val=""/>
  <dgm:desc val=""/>
  <dgm:catLst>
    <dgm:cat type="3D" pri="111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flat" dir="t"/>
    </dgm:scene3d>
    <dgm:sp3d z="1270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flat" dir="t"/>
    </dgm:scene3d>
    <dgm:sp3d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flat" dir="t"/>
    </dgm:scene3d>
    <dgm:sp3d z="-1905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flat" dir="t"/>
    </dgm:scene3d>
    <dgm:sp3d z="-80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flat" dir="t"/>
    </dgm:scene3d>
    <dgm:sp3d z="127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flat" dir="t"/>
    </dgm:scene3d>
    <dgm:sp3d z="-1905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flat" dir="t"/>
    </dgm:scene3d>
    <dgm:sp3d z="-40000" prstMaterial="matte"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 z="127000" prstMaterial="matte"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flat" dir="t"/>
    </dgm:scene3d>
    <dgm:sp3d z="-10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FollowNode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flat" dir="t"/>
    </dgm:scene3d>
    <dgm:sp3d z="-190500" extrusionH="12700" prstMaterial="matte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z="190500"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43B2FD-B466-48CF-AA8F-6326E0125B89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4D343C-B8AF-493B-8B5F-4BB9B0744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7077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4D343C-B8AF-493B-8B5F-4BB9B0744C5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160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47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795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84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351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46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84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461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332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597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645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660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401BB-124D-4F81-BF35-8D611FF47EAF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F8CD32-4083-49BC-BDC5-A435C42FA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643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Colors" Target="../diagrams/colors1.xml"/><Relationship Id="rId13" Type="http://schemas.openxmlformats.org/officeDocument/2006/relationships/diagramColors" Target="../diagrams/colors2.xml"/><Relationship Id="rId3" Type="http://schemas.openxmlformats.org/officeDocument/2006/relationships/image" Target="../media/image1.png"/><Relationship Id="rId7" Type="http://schemas.openxmlformats.org/officeDocument/2006/relationships/diagramQuickStyle" Target="../diagrams/quickStyle1.xml"/><Relationship Id="rId12" Type="http://schemas.openxmlformats.org/officeDocument/2006/relationships/diagramQuickStyle" Target="../diagrams/quickStyle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diagramLayout" Target="../diagrams/layout1.xml"/><Relationship Id="rId11" Type="http://schemas.openxmlformats.org/officeDocument/2006/relationships/diagramLayout" Target="../diagrams/layout2.xml"/><Relationship Id="rId5" Type="http://schemas.openxmlformats.org/officeDocument/2006/relationships/diagramData" Target="../diagrams/data1.xml"/><Relationship Id="rId10" Type="http://schemas.openxmlformats.org/officeDocument/2006/relationships/diagramData" Target="../diagrams/data2.xml"/><Relationship Id="rId4" Type="http://schemas.openxmlformats.org/officeDocument/2006/relationships/image" Target="../media/image2.png"/><Relationship Id="rId9" Type="http://schemas.microsoft.com/office/2007/relationships/diagramDrawing" Target="../diagrams/drawing1.xml"/><Relationship Id="rId14" Type="http://schemas.microsoft.com/office/2007/relationships/diagramDrawing" Target="../diagrams/drawin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>
            <a:extLst>
              <a:ext uri="{FF2B5EF4-FFF2-40B4-BE49-F238E27FC236}">
                <a16:creationId xmlns:a16="http://schemas.microsoft.com/office/drawing/2014/main" id="{B10ACAD9-BCEA-4853-812C-53CFE9FA5BA9}"/>
              </a:ext>
            </a:extLst>
          </p:cNvPr>
          <p:cNvSpPr/>
          <p:nvPr/>
        </p:nvSpPr>
        <p:spPr>
          <a:xfrm>
            <a:off x="103030" y="49245"/>
            <a:ext cx="6658377" cy="8847786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2AF0BC6-47DD-44C9-8CEF-4F203828DE8D}"/>
              </a:ext>
            </a:extLst>
          </p:cNvPr>
          <p:cNvGrpSpPr/>
          <p:nvPr/>
        </p:nvGrpSpPr>
        <p:grpSpPr>
          <a:xfrm>
            <a:off x="3476357" y="4141876"/>
            <a:ext cx="3049457" cy="3318901"/>
            <a:chOff x="1403379" y="895526"/>
            <a:chExt cx="3049457" cy="3254507"/>
          </a:xfrm>
          <a:scene3d>
            <a:camera prst="orthographicFront"/>
            <a:lightRig rig="flat" dir="t"/>
          </a:scene3d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7D47DE1-353F-46AB-A5B2-115212644DF1}"/>
                </a:ext>
              </a:extLst>
            </p:cNvPr>
            <p:cNvSpPr txBox="1"/>
            <p:nvPr/>
          </p:nvSpPr>
          <p:spPr>
            <a:xfrm>
              <a:off x="1403379" y="895526"/>
              <a:ext cx="2984080" cy="1633275"/>
            </a:xfrm>
            <a:prstGeom prst="rect">
              <a:avLst/>
            </a:prstGeom>
            <a:sp3d z="190500"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231598" tIns="354076" rIns="231598" bIns="85344" numCol="1" spcCol="1270" anchor="t" anchorCtr="0">
              <a:noAutofit/>
            </a:bodyPr>
            <a:lstStyle/>
            <a:p>
              <a:pPr marL="0" lvl="1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</a:pPr>
              <a:endParaRPr lang="en-US" sz="12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FEACE6F1-6A0D-44BE-8EA4-2E5657BA3C5B}"/>
                </a:ext>
              </a:extLst>
            </p:cNvPr>
            <p:cNvSpPr/>
            <p:nvPr/>
          </p:nvSpPr>
          <p:spPr>
            <a:xfrm>
              <a:off x="1468756" y="895526"/>
              <a:ext cx="2984080" cy="3254507"/>
            </a:xfrm>
            <a:prstGeom prst="rect">
              <a:avLst/>
            </a:prstGeom>
            <a:sp3d z="190500" extrusionH="12700" prstMaterial="plastic">
              <a:bevelT w="50800" h="50800"/>
            </a:sp3d>
          </p:spPr>
          <p:style>
            <a:lnRef idx="1">
              <a:schemeClr val="accent5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2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3C37C723-9B74-48D3-8E05-A4DFBA501DCC}"/>
              </a:ext>
            </a:extLst>
          </p:cNvPr>
          <p:cNvSpPr txBox="1"/>
          <p:nvPr/>
        </p:nvSpPr>
        <p:spPr>
          <a:xfrm>
            <a:off x="1280796" y="223922"/>
            <a:ext cx="529788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 Rounded MT Bold" panose="020F0704030504030204" pitchFamily="34" charset="0"/>
              </a:rPr>
              <a:t>Are you Interested in a </a:t>
            </a:r>
          </a:p>
          <a:p>
            <a:pPr algn="ctr"/>
            <a:r>
              <a:rPr lang="en-US" sz="2000" b="1" dirty="0">
                <a:latin typeface="Arial Rounded MT Bold" panose="020F0704030504030204" pitchFamily="34" charset="0"/>
              </a:rPr>
              <a:t>Partnered Complementary and Integrative Health</a:t>
            </a:r>
          </a:p>
          <a:p>
            <a:pPr algn="ctr"/>
            <a:r>
              <a:rPr lang="en-US" sz="1600" b="1" dirty="0">
                <a:latin typeface="Arial Rounded MT Bold" panose="020F0704030504030204" pitchFamily="34" charset="0"/>
              </a:rPr>
              <a:t>Research Project?</a:t>
            </a:r>
          </a:p>
          <a:p>
            <a:pPr algn="ctr"/>
            <a:endParaRPr lang="en-US" sz="1600" b="1" dirty="0">
              <a:latin typeface="Arial Rounded MT Bold" panose="020F0704030504030204" pitchFamily="34" charset="0"/>
            </a:endParaRPr>
          </a:p>
        </p:txBody>
      </p:sp>
      <p:pic>
        <p:nvPicPr>
          <p:cNvPr id="9" name="Picture 1" descr="1920px-Seal_of_the_U_S__Department_of_Veterans_Affairs_svg">
            <a:extLst>
              <a:ext uri="{FF2B5EF4-FFF2-40B4-BE49-F238E27FC236}">
                <a16:creationId xmlns:a16="http://schemas.microsoft.com/office/drawing/2014/main" id="{B847FA19-2350-41AA-AED9-0636926DF7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050" y="246969"/>
            <a:ext cx="1100746" cy="11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87ECC7BB-D537-46DD-884A-64B69D158609}"/>
              </a:ext>
            </a:extLst>
          </p:cNvPr>
          <p:cNvGrpSpPr/>
          <p:nvPr/>
        </p:nvGrpSpPr>
        <p:grpSpPr>
          <a:xfrm>
            <a:off x="169146" y="1754615"/>
            <a:ext cx="6155274" cy="2155540"/>
            <a:chOff x="245525" y="1955106"/>
            <a:chExt cx="6155274" cy="215554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5B8D4DE-15F2-4E19-ACAB-93AE79ADFCA4}"/>
                </a:ext>
              </a:extLst>
            </p:cNvPr>
            <p:cNvSpPr txBox="1"/>
            <p:nvPr/>
          </p:nvSpPr>
          <p:spPr>
            <a:xfrm>
              <a:off x="1457738" y="1955106"/>
              <a:ext cx="49430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400" dirty="0"/>
            </a:p>
          </p:txBody>
        </p:sp>
        <p:pic>
          <p:nvPicPr>
            <p:cNvPr id="12" name="Picture 11" descr="Fig7 MR App.png">
              <a:extLst>
                <a:ext uri="{FF2B5EF4-FFF2-40B4-BE49-F238E27FC236}">
                  <a16:creationId xmlns:a16="http://schemas.microsoft.com/office/drawing/2014/main" id="{2B27A423-0E7A-4E85-8AEB-D9A4FAE45487}"/>
                </a:ext>
              </a:extLst>
            </p:cNvPr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245525" y="1955106"/>
              <a:ext cx="1212213" cy="2155540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8B642A69-3FAC-4A53-AE66-2CA4546B0312}"/>
              </a:ext>
            </a:extLst>
          </p:cNvPr>
          <p:cNvSpPr txBox="1"/>
          <p:nvPr/>
        </p:nvSpPr>
        <p:spPr>
          <a:xfrm>
            <a:off x="3529225" y="7748631"/>
            <a:ext cx="2984080" cy="98488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incipal Investigator Jolie Haun, PhD,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search &amp; Development James A. Haley VA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niversity of South Florida IRB # Pro00035440</a:t>
            </a:r>
            <a:endParaRPr lang="en-US" sz="8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Contact for more information: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sa Ballistrea (Project Coordinator)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13-558-7637 </a:t>
            </a:r>
            <a:endParaRPr lang="en-US" sz="1000" strike="sngStrike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68F0BC7A-C85A-4407-8FE4-6E264C00569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98932762"/>
              </p:ext>
            </p:extLst>
          </p:nvPr>
        </p:nvGraphicFramePr>
        <p:xfrm>
          <a:off x="262703" y="4108175"/>
          <a:ext cx="2984080" cy="478885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5" r:lo="rId6" r:qs="rId7" r:cs="rId8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D3B52838-66E1-4071-AB21-FEC8456BEAE7}"/>
              </a:ext>
            </a:extLst>
          </p:cNvPr>
          <p:cNvSpPr/>
          <p:nvPr/>
        </p:nvSpPr>
        <p:spPr>
          <a:xfrm>
            <a:off x="956267" y="1330147"/>
            <a:ext cx="4951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t’s as easy as using a mobile app on your phone!</a:t>
            </a:r>
          </a:p>
        </p:txBody>
      </p:sp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D3BB8436-CCA4-4DB5-9D45-4CE604332FF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35108119"/>
              </p:ext>
            </p:extLst>
          </p:nvPr>
        </p:nvGraphicFramePr>
        <p:xfrm>
          <a:off x="3714338" y="4770784"/>
          <a:ext cx="2798967" cy="285350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0" r:lo="rId11" r:qs="rId12" r:cs="rId13"/>
          </a:graphicData>
        </a:graphic>
      </p:graphicFrame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9047F3E9-DD89-419B-82E8-7E863F6D9753}"/>
              </a:ext>
            </a:extLst>
          </p:cNvPr>
          <p:cNvSpPr/>
          <p:nvPr/>
        </p:nvSpPr>
        <p:spPr>
          <a:xfrm>
            <a:off x="3714338" y="4108174"/>
            <a:ext cx="2383261" cy="662609"/>
          </a:xfrm>
          <a:prstGeom prst="roundRect">
            <a:avLst/>
          </a:prstGeom>
          <a:gradFill rotWithShape="0">
            <a:gsLst>
              <a:gs pos="0">
                <a:srgbClr val="5B9BD5">
                  <a:hueOff val="0"/>
                  <a:satOff val="0"/>
                  <a:lumOff val="0"/>
                  <a:alphaOff val="0"/>
                  <a:satMod val="103000"/>
                  <a:lumMod val="102000"/>
                  <a:tint val="94000"/>
                </a:srgbClr>
              </a:gs>
              <a:gs pos="50000">
                <a:srgbClr val="5B9BD5">
                  <a:hueOff val="0"/>
                  <a:satOff val="0"/>
                  <a:lumOff val="0"/>
                  <a:alphaOff val="0"/>
                  <a:satMod val="110000"/>
                  <a:lumMod val="100000"/>
                  <a:shade val="100000"/>
                </a:srgbClr>
              </a:gs>
              <a:gs pos="100000">
                <a:srgbClr val="5B9BD5">
                  <a:hueOff val="0"/>
                  <a:satOff val="0"/>
                  <a:lumOff val="0"/>
                  <a:alphaOff val="0"/>
                  <a:lumMod val="99000"/>
                  <a:satMod val="120000"/>
                  <a:shade val="78000"/>
                </a:srgbClr>
              </a:gs>
            </a:gsLst>
            <a:lin ang="5400000" scaled="0"/>
          </a:gradFill>
          <a:ln>
            <a:noFill/>
          </a:ln>
          <a:effectLst/>
          <a:scene3d>
            <a:camera prst="orthographicFront"/>
            <a:lightRig rig="flat" dir="t"/>
          </a:scene3d>
          <a:sp3d prstMaterial="plastic">
            <a:bevelT w="120900" h="88900"/>
            <a:bevelB w="88900" h="31750" prst="angle"/>
          </a:sp3d>
        </p:spPr>
        <p:txBody>
          <a:bodyPr spcFirstLastPara="0" vert="horz" wrap="square" lIns="86075" tIns="0" rIns="86075" bIns="0" numCol="1" spcCol="1270" anchor="ctr" anchorCtr="0">
            <a:no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rticipants and their partners will perform activities such as: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A5AB37E-FC5E-CA12-2807-CBA445DE01B7}"/>
              </a:ext>
            </a:extLst>
          </p:cNvPr>
          <p:cNvGrpSpPr/>
          <p:nvPr/>
        </p:nvGrpSpPr>
        <p:grpSpPr>
          <a:xfrm>
            <a:off x="1386912" y="1651417"/>
            <a:ext cx="5119068" cy="2316260"/>
            <a:chOff x="1386912" y="1651417"/>
            <a:chExt cx="5119068" cy="2316260"/>
          </a:xfrm>
        </p:grpSpPr>
        <p:sp>
          <p:nvSpPr>
            <p:cNvPr id="6" name="Freeform: Shape 5">
              <a:extLst>
                <a:ext uri="{FF2B5EF4-FFF2-40B4-BE49-F238E27FC236}">
                  <a16:creationId xmlns:a16="http://schemas.microsoft.com/office/drawing/2014/main" id="{D7F62713-48FA-AB68-7301-A418D55124F5}"/>
                </a:ext>
              </a:extLst>
            </p:cNvPr>
            <p:cNvSpPr/>
            <p:nvPr/>
          </p:nvSpPr>
          <p:spPr>
            <a:xfrm>
              <a:off x="1386912" y="1824859"/>
              <a:ext cx="5119068" cy="1044278"/>
            </a:xfrm>
            <a:custGeom>
              <a:avLst/>
              <a:gdLst>
                <a:gd name="connsiteX0" fmla="*/ 0 w 5119068"/>
                <a:gd name="connsiteY0" fmla="*/ 0 h 1197000"/>
                <a:gd name="connsiteX1" fmla="*/ 5119068 w 5119068"/>
                <a:gd name="connsiteY1" fmla="*/ 0 h 1197000"/>
                <a:gd name="connsiteX2" fmla="*/ 5119068 w 5119068"/>
                <a:gd name="connsiteY2" fmla="*/ 1197000 h 1197000"/>
                <a:gd name="connsiteX3" fmla="*/ 0 w 5119068"/>
                <a:gd name="connsiteY3" fmla="*/ 1197000 h 1197000"/>
                <a:gd name="connsiteX4" fmla="*/ 0 w 5119068"/>
                <a:gd name="connsiteY4" fmla="*/ 0 h 1197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119068" h="1197000">
                  <a:moveTo>
                    <a:pt x="0" y="0"/>
                  </a:moveTo>
                  <a:lnTo>
                    <a:pt x="5119068" y="0"/>
                  </a:lnTo>
                  <a:lnTo>
                    <a:pt x="5119068" y="1197000"/>
                  </a:lnTo>
                  <a:lnTo>
                    <a:pt x="0" y="1197000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z="190500" extrusionH="12700" prstMaterial="plastic">
              <a:bevelT w="50800" h="50800"/>
            </a:sp3d>
          </p:spPr>
          <p:style>
            <a:lnRef idx="1">
              <a:schemeClr val="accent5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2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97297" tIns="104140" rIns="397297" bIns="85344" numCol="1" spcCol="1270" anchor="t" anchorCtr="0">
              <a:noAutofit/>
            </a:bodyPr>
            <a:lstStyle/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We are recruiting for Veterans and their partner to test</a:t>
              </a:r>
              <a:r>
                <a:rPr lang="en-US" sz="1200" b="0" kern="1200" spc="-5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the effects of Mission Reconnect (MR).</a:t>
              </a:r>
            </a:p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MR is an online program that helps veterans and their partners reduce pain, anxiety &amp; stress through complimentary integrated health activities. (i.e. massage, meditation, yoga)</a:t>
              </a:r>
            </a:p>
          </p:txBody>
        </p:sp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D88515CB-42C5-2A3F-25B9-2A129CE4C9AA}"/>
                </a:ext>
              </a:extLst>
            </p:cNvPr>
            <p:cNvSpPr/>
            <p:nvPr/>
          </p:nvSpPr>
          <p:spPr>
            <a:xfrm>
              <a:off x="1642865" y="1651417"/>
              <a:ext cx="3583347" cy="233735"/>
            </a:xfrm>
            <a:custGeom>
              <a:avLst/>
              <a:gdLst>
                <a:gd name="connsiteX0" fmla="*/ 0 w 3583347"/>
                <a:gd name="connsiteY0" fmla="*/ 21757 h 130537"/>
                <a:gd name="connsiteX1" fmla="*/ 21757 w 3583347"/>
                <a:gd name="connsiteY1" fmla="*/ 0 h 130537"/>
                <a:gd name="connsiteX2" fmla="*/ 3561590 w 3583347"/>
                <a:gd name="connsiteY2" fmla="*/ 0 h 130537"/>
                <a:gd name="connsiteX3" fmla="*/ 3583347 w 3583347"/>
                <a:gd name="connsiteY3" fmla="*/ 21757 h 130537"/>
                <a:gd name="connsiteX4" fmla="*/ 3583347 w 3583347"/>
                <a:gd name="connsiteY4" fmla="*/ 108780 h 130537"/>
                <a:gd name="connsiteX5" fmla="*/ 3561590 w 3583347"/>
                <a:gd name="connsiteY5" fmla="*/ 130537 h 130537"/>
                <a:gd name="connsiteX6" fmla="*/ 21757 w 3583347"/>
                <a:gd name="connsiteY6" fmla="*/ 130537 h 130537"/>
                <a:gd name="connsiteX7" fmla="*/ 0 w 3583347"/>
                <a:gd name="connsiteY7" fmla="*/ 108780 h 130537"/>
                <a:gd name="connsiteX8" fmla="*/ 0 w 3583347"/>
                <a:gd name="connsiteY8" fmla="*/ 21757 h 130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583347" h="130537">
                  <a:moveTo>
                    <a:pt x="0" y="21757"/>
                  </a:moveTo>
                  <a:cubicBezTo>
                    <a:pt x="0" y="9741"/>
                    <a:pt x="9741" y="0"/>
                    <a:pt x="21757" y="0"/>
                  </a:cubicBezTo>
                  <a:lnTo>
                    <a:pt x="3561590" y="0"/>
                  </a:lnTo>
                  <a:cubicBezTo>
                    <a:pt x="3573606" y="0"/>
                    <a:pt x="3583347" y="9741"/>
                    <a:pt x="3583347" y="21757"/>
                  </a:cubicBezTo>
                  <a:lnTo>
                    <a:pt x="3583347" y="108780"/>
                  </a:lnTo>
                  <a:cubicBezTo>
                    <a:pt x="3583347" y="120796"/>
                    <a:pt x="3573606" y="130537"/>
                    <a:pt x="3561590" y="130537"/>
                  </a:cubicBezTo>
                  <a:lnTo>
                    <a:pt x="21757" y="130537"/>
                  </a:lnTo>
                  <a:cubicBezTo>
                    <a:pt x="9741" y="130537"/>
                    <a:pt x="0" y="120796"/>
                    <a:pt x="0" y="108780"/>
                  </a:cubicBezTo>
                  <a:lnTo>
                    <a:pt x="0" y="21757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plastic">
              <a:bevelT w="120900" h="88900"/>
              <a:bevelB w="88900" h="31750" prst="angle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3">
              <a:schemeClr val="accent5">
                <a:hueOff val="0"/>
                <a:satOff val="0"/>
                <a:lumOff val="0"/>
                <a:alphaOff val="0"/>
              </a:schemeClr>
            </a:fillRef>
            <a:effectRef idx="2">
              <a:schemeClr val="accent5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39808" tIns="6372" rIns="139808" bIns="6372" numCol="1" spcCol="1270" anchor="ctr" anchorCtr="0">
              <a:noAutofit/>
            </a:bodyPr>
            <a:lstStyle/>
            <a:p>
              <a:pPr marL="0" lvl="0" indent="0" algn="l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400" b="1" kern="1200" dirty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re</a:t>
              </a:r>
              <a:r>
                <a:rPr lang="en-US" sz="1400" b="1" kern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you interested?</a:t>
              </a:r>
            </a:p>
          </p:txBody>
        </p:sp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9BE0522C-D365-5DEA-7A98-565876297A76}"/>
                </a:ext>
              </a:extLst>
            </p:cNvPr>
            <p:cNvSpPr/>
            <p:nvPr/>
          </p:nvSpPr>
          <p:spPr>
            <a:xfrm>
              <a:off x="1386912" y="3117177"/>
              <a:ext cx="5119068" cy="850500"/>
            </a:xfrm>
            <a:custGeom>
              <a:avLst/>
              <a:gdLst>
                <a:gd name="connsiteX0" fmla="*/ 0 w 5119068"/>
                <a:gd name="connsiteY0" fmla="*/ 0 h 850500"/>
                <a:gd name="connsiteX1" fmla="*/ 5119068 w 5119068"/>
                <a:gd name="connsiteY1" fmla="*/ 0 h 850500"/>
                <a:gd name="connsiteX2" fmla="*/ 5119068 w 5119068"/>
                <a:gd name="connsiteY2" fmla="*/ 850500 h 850500"/>
                <a:gd name="connsiteX3" fmla="*/ 0 w 5119068"/>
                <a:gd name="connsiteY3" fmla="*/ 850500 h 850500"/>
                <a:gd name="connsiteX4" fmla="*/ 0 w 5119068"/>
                <a:gd name="connsiteY4" fmla="*/ 0 h 850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119068" h="850500">
                  <a:moveTo>
                    <a:pt x="0" y="0"/>
                  </a:moveTo>
                  <a:lnTo>
                    <a:pt x="5119068" y="0"/>
                  </a:lnTo>
                  <a:lnTo>
                    <a:pt x="5119068" y="850500"/>
                  </a:lnTo>
                  <a:lnTo>
                    <a:pt x="0" y="850500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z="190500" extrusionH="12700" prstMaterial="plastic">
              <a:bevelT w="50800" h="50800"/>
            </a:sp3d>
          </p:spPr>
          <p:style>
            <a:lnRef idx="1">
              <a:schemeClr val="accent5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2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97297" tIns="104140" rIns="397297" bIns="85344" numCol="1" spcCol="1270" anchor="t" anchorCtr="0">
              <a:noAutofit/>
            </a:bodyPr>
            <a:lstStyle/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MR teaches Veterans and their partners techniques to promote well-being &amp; improve relationship quality. </a:t>
              </a:r>
            </a:p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The goal of the study is to test MR as an approach to manage chronic pain &amp; PTSD symptoms.</a:t>
              </a:r>
            </a:p>
          </p:txBody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DA2156E0-F261-1D48-A34C-F6217173353D}"/>
                </a:ext>
              </a:extLst>
            </p:cNvPr>
            <p:cNvSpPr/>
            <p:nvPr/>
          </p:nvSpPr>
          <p:spPr>
            <a:xfrm>
              <a:off x="1642615" y="2946452"/>
              <a:ext cx="3579848" cy="244524"/>
            </a:xfrm>
            <a:custGeom>
              <a:avLst/>
              <a:gdLst>
                <a:gd name="connsiteX0" fmla="*/ 0 w 3579848"/>
                <a:gd name="connsiteY0" fmla="*/ 40755 h 244524"/>
                <a:gd name="connsiteX1" fmla="*/ 40755 w 3579848"/>
                <a:gd name="connsiteY1" fmla="*/ 0 h 244524"/>
                <a:gd name="connsiteX2" fmla="*/ 3539093 w 3579848"/>
                <a:gd name="connsiteY2" fmla="*/ 0 h 244524"/>
                <a:gd name="connsiteX3" fmla="*/ 3579848 w 3579848"/>
                <a:gd name="connsiteY3" fmla="*/ 40755 h 244524"/>
                <a:gd name="connsiteX4" fmla="*/ 3579848 w 3579848"/>
                <a:gd name="connsiteY4" fmla="*/ 203769 h 244524"/>
                <a:gd name="connsiteX5" fmla="*/ 3539093 w 3579848"/>
                <a:gd name="connsiteY5" fmla="*/ 244524 h 244524"/>
                <a:gd name="connsiteX6" fmla="*/ 40755 w 3579848"/>
                <a:gd name="connsiteY6" fmla="*/ 244524 h 244524"/>
                <a:gd name="connsiteX7" fmla="*/ 0 w 3579848"/>
                <a:gd name="connsiteY7" fmla="*/ 203769 h 244524"/>
                <a:gd name="connsiteX8" fmla="*/ 0 w 3579848"/>
                <a:gd name="connsiteY8" fmla="*/ 40755 h 2445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579848" h="244524">
                  <a:moveTo>
                    <a:pt x="0" y="40755"/>
                  </a:moveTo>
                  <a:cubicBezTo>
                    <a:pt x="0" y="18247"/>
                    <a:pt x="18247" y="0"/>
                    <a:pt x="40755" y="0"/>
                  </a:cubicBezTo>
                  <a:lnTo>
                    <a:pt x="3539093" y="0"/>
                  </a:lnTo>
                  <a:cubicBezTo>
                    <a:pt x="3561601" y="0"/>
                    <a:pt x="3579848" y="18247"/>
                    <a:pt x="3579848" y="40755"/>
                  </a:cubicBezTo>
                  <a:lnTo>
                    <a:pt x="3579848" y="203769"/>
                  </a:lnTo>
                  <a:cubicBezTo>
                    <a:pt x="3579848" y="226277"/>
                    <a:pt x="3561601" y="244524"/>
                    <a:pt x="3539093" y="244524"/>
                  </a:cubicBezTo>
                  <a:lnTo>
                    <a:pt x="40755" y="244524"/>
                  </a:lnTo>
                  <a:cubicBezTo>
                    <a:pt x="18247" y="244524"/>
                    <a:pt x="0" y="226277"/>
                    <a:pt x="0" y="203769"/>
                  </a:cubicBezTo>
                  <a:lnTo>
                    <a:pt x="0" y="40755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plastic">
              <a:bevelT w="120900" h="88900"/>
              <a:bevelB w="88900" h="31750" prst="angle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3">
              <a:schemeClr val="accent5">
                <a:hueOff val="0"/>
                <a:satOff val="0"/>
                <a:lumOff val="0"/>
                <a:alphaOff val="0"/>
              </a:schemeClr>
            </a:fillRef>
            <a:effectRef idx="2">
              <a:schemeClr val="accent5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47379" tIns="11937" rIns="147379" bIns="11937" numCol="1" spcCol="1270" anchor="ctr" anchorCtr="0">
              <a:noAutofit/>
            </a:bodyPr>
            <a:lstStyle/>
            <a:p>
              <a:pPr marL="0" lvl="0" indent="0" algn="l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400" b="1" kern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hat is this study about?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35816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257</Words>
  <Application>Microsoft Office PowerPoint</Application>
  <PresentationFormat>Letter Paper (8.5x11 in)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Rounded MT Bold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ff, Lisa M.</dc:creator>
  <cp:lastModifiedBy>Benzinger, Rachel C.</cp:lastModifiedBy>
  <cp:revision>60</cp:revision>
  <dcterms:created xsi:type="dcterms:W3CDTF">2018-11-14T21:07:21Z</dcterms:created>
  <dcterms:modified xsi:type="dcterms:W3CDTF">2023-09-29T15:34:42Z</dcterms:modified>
</cp:coreProperties>
</file>